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64" r:id="rId2"/>
    <p:sldId id="262" r:id="rId3"/>
    <p:sldId id="268" r:id="rId4"/>
    <p:sldId id="265" r:id="rId5"/>
    <p:sldId id="260" r:id="rId6"/>
    <p:sldId id="269" r:id="rId7"/>
  </p:sldIdLst>
  <p:sldSz cx="34199513" cy="467995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39AF44-58AE-6C4F-8FFA-A1423405AB76}" v="268" dt="2024-10-23T16:30:34.400"/>
    <p1510:client id="{9D68DCDA-2B93-4B58-BDFB-3EA6DDACA25B}" v="29" dt="2024-10-23T14:28:10.73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scini Anna Sofia" userId="813f6bb4-81f2-4424-b468-a0a8a3b22e60" providerId="ADAL" clId="{5639AF44-58AE-6C4F-8FFA-A1423405AB76}"/>
    <pc:docChg chg="undo custSel addSld delSld modSld sldOrd">
      <pc:chgData name="Tascini Anna Sofia" userId="813f6bb4-81f2-4424-b468-a0a8a3b22e60" providerId="ADAL" clId="{5639AF44-58AE-6C4F-8FFA-A1423405AB76}" dt="2024-10-23T16:30:34.400" v="557" actId="1076"/>
      <pc:docMkLst>
        <pc:docMk/>
      </pc:docMkLst>
      <pc:sldChg chg="delSp modSp mod">
        <pc:chgData name="Tascini Anna Sofia" userId="813f6bb4-81f2-4424-b468-a0a8a3b22e60" providerId="ADAL" clId="{5639AF44-58AE-6C4F-8FFA-A1423405AB76}" dt="2024-10-22T07:31:41.429" v="291" actId="21"/>
        <pc:sldMkLst>
          <pc:docMk/>
          <pc:sldMk cId="629443125" sldId="260"/>
        </pc:sldMkLst>
        <pc:spChg chg="mod">
          <ac:chgData name="Tascini Anna Sofia" userId="813f6bb4-81f2-4424-b468-a0a8a3b22e60" providerId="ADAL" clId="{5639AF44-58AE-6C4F-8FFA-A1423405AB76}" dt="2024-10-17T15:44:44.727" v="267" actId="20577"/>
          <ac:spMkLst>
            <pc:docMk/>
            <pc:sldMk cId="629443125" sldId="260"/>
            <ac:spMk id="2" creationId="{9BF5AF13-EDA7-086C-4CCB-7247B1DE2E0D}"/>
          </ac:spMkLst>
        </pc:spChg>
        <pc:picChg chg="del">
          <ac:chgData name="Tascini Anna Sofia" userId="813f6bb4-81f2-4424-b468-a0a8a3b22e60" providerId="ADAL" clId="{5639AF44-58AE-6C4F-8FFA-A1423405AB76}" dt="2024-10-22T07:31:41.429" v="291" actId="21"/>
          <ac:picMkLst>
            <pc:docMk/>
            <pc:sldMk cId="629443125" sldId="260"/>
            <ac:picMk id="26" creationId="{EF1613BD-C578-AA4F-E795-25359DE2E95A}"/>
          </ac:picMkLst>
        </pc:picChg>
      </pc:sldChg>
      <pc:sldChg chg="modSp mod ord">
        <pc:chgData name="Tascini Anna Sofia" userId="813f6bb4-81f2-4424-b468-a0a8a3b22e60" providerId="ADAL" clId="{5639AF44-58AE-6C4F-8FFA-A1423405AB76}" dt="2024-10-17T15:47:45.838" v="280" actId="20577"/>
        <pc:sldMkLst>
          <pc:docMk/>
          <pc:sldMk cId="867644236" sldId="262"/>
        </pc:sldMkLst>
        <pc:spChg chg="mod">
          <ac:chgData name="Tascini Anna Sofia" userId="813f6bb4-81f2-4424-b468-a0a8a3b22e60" providerId="ADAL" clId="{5639AF44-58AE-6C4F-8FFA-A1423405AB76}" dt="2024-10-17T15:47:45.838" v="280" actId="20577"/>
          <ac:spMkLst>
            <pc:docMk/>
            <pc:sldMk cId="867644236" sldId="262"/>
            <ac:spMk id="2" creationId="{9BF5AF13-EDA7-086C-4CCB-7247B1DE2E0D}"/>
          </ac:spMkLst>
        </pc:spChg>
      </pc:sldChg>
      <pc:sldChg chg="modSp mod ord">
        <pc:chgData name="Tascini Anna Sofia" userId="813f6bb4-81f2-4424-b468-a0a8a3b22e60" providerId="ADAL" clId="{5639AF44-58AE-6C4F-8FFA-A1423405AB76}" dt="2024-10-17T15:52:08.167" v="290" actId="20577"/>
        <pc:sldMkLst>
          <pc:docMk/>
          <pc:sldMk cId="3866903768" sldId="265"/>
        </pc:sldMkLst>
        <pc:spChg chg="mod">
          <ac:chgData name="Tascini Anna Sofia" userId="813f6bb4-81f2-4424-b468-a0a8a3b22e60" providerId="ADAL" clId="{5639AF44-58AE-6C4F-8FFA-A1423405AB76}" dt="2024-10-17T15:52:08.167" v="290" actId="20577"/>
          <ac:spMkLst>
            <pc:docMk/>
            <pc:sldMk cId="3866903768" sldId="265"/>
            <ac:spMk id="8" creationId="{88E546CA-30C6-F9DB-9C8A-290C176A8A44}"/>
          </ac:spMkLst>
        </pc:spChg>
      </pc:sldChg>
      <pc:sldChg chg="addSp delSp modSp new del mod modNotesTx">
        <pc:chgData name="Tascini Anna Sofia" userId="813f6bb4-81f2-4424-b468-a0a8a3b22e60" providerId="ADAL" clId="{5639AF44-58AE-6C4F-8FFA-A1423405AB76}" dt="2024-10-16T15:26:52.371" v="241" actId="2696"/>
        <pc:sldMkLst>
          <pc:docMk/>
          <pc:sldMk cId="1648501261" sldId="266"/>
        </pc:sldMkLst>
        <pc:spChg chg="add mod">
          <ac:chgData name="Tascini Anna Sofia" userId="813f6bb4-81f2-4424-b468-a0a8a3b22e60" providerId="ADAL" clId="{5639AF44-58AE-6C4F-8FFA-A1423405AB76}" dt="2024-10-16T15:15:53.715" v="55" actId="13926"/>
          <ac:spMkLst>
            <pc:docMk/>
            <pc:sldMk cId="1648501261" sldId="266"/>
            <ac:spMk id="5" creationId="{BFC4AFAE-DABA-474A-BA91-727B03B251A7}"/>
          </ac:spMkLst>
        </pc:spChg>
        <pc:spChg chg="add mod">
          <ac:chgData name="Tascini Anna Sofia" userId="813f6bb4-81f2-4424-b468-a0a8a3b22e60" providerId="ADAL" clId="{5639AF44-58AE-6C4F-8FFA-A1423405AB76}" dt="2024-10-16T15:19:34.500" v="144" actId="1076"/>
          <ac:spMkLst>
            <pc:docMk/>
            <pc:sldMk cId="1648501261" sldId="266"/>
            <ac:spMk id="7" creationId="{9E8C5116-1282-0DD5-B83D-2EC3A2B3F089}"/>
          </ac:spMkLst>
        </pc:spChg>
        <pc:spChg chg="add mod">
          <ac:chgData name="Tascini Anna Sofia" userId="813f6bb4-81f2-4424-b468-a0a8a3b22e60" providerId="ADAL" clId="{5639AF44-58AE-6C4F-8FFA-A1423405AB76}" dt="2024-10-16T15:20:31.880" v="148" actId="20577"/>
          <ac:spMkLst>
            <pc:docMk/>
            <pc:sldMk cId="1648501261" sldId="266"/>
            <ac:spMk id="9" creationId="{98655E2A-48C1-F9C8-6991-45CA72AA30D5}"/>
          </ac:spMkLst>
        </pc:spChg>
        <pc:graphicFrameChg chg="add del mod modGraphic">
          <ac:chgData name="Tascini Anna Sofia" userId="813f6bb4-81f2-4424-b468-a0a8a3b22e60" providerId="ADAL" clId="{5639AF44-58AE-6C4F-8FFA-A1423405AB76}" dt="2024-10-16T15:11:06.706" v="9" actId="478"/>
          <ac:graphicFrameMkLst>
            <pc:docMk/>
            <pc:sldMk cId="1648501261" sldId="266"/>
            <ac:graphicFrameMk id="2" creationId="{94EB96AB-7D26-0355-77BE-016957017AA5}"/>
          </ac:graphicFrameMkLst>
        </pc:graphicFrameChg>
        <pc:graphicFrameChg chg="add mod modGraphic">
          <ac:chgData name="Tascini Anna Sofia" userId="813f6bb4-81f2-4424-b468-a0a8a3b22e60" providerId="ADAL" clId="{5639AF44-58AE-6C4F-8FFA-A1423405AB76}" dt="2024-10-16T15:13:23.827" v="21" actId="12385"/>
          <ac:graphicFrameMkLst>
            <pc:docMk/>
            <pc:sldMk cId="1648501261" sldId="266"/>
            <ac:graphicFrameMk id="3" creationId="{4FB6A434-891D-37ED-9DF8-F5B5DE930DEC}"/>
          </ac:graphicFrameMkLst>
        </pc:graphicFrameChg>
        <pc:graphicFrameChg chg="add del mod modGraphic">
          <ac:chgData name="Tascini Anna Sofia" userId="813f6bb4-81f2-4424-b468-a0a8a3b22e60" providerId="ADAL" clId="{5639AF44-58AE-6C4F-8FFA-A1423405AB76}" dt="2024-10-16T15:26:49.771" v="240" actId="478"/>
          <ac:graphicFrameMkLst>
            <pc:docMk/>
            <pc:sldMk cId="1648501261" sldId="266"/>
            <ac:graphicFrameMk id="8" creationId="{D61A0424-22A0-11E3-EFC6-FF67EE94D247}"/>
          </ac:graphicFrameMkLst>
        </pc:graphicFrameChg>
      </pc:sldChg>
      <pc:sldChg chg="addSp modSp new del mod modNotesTx">
        <pc:chgData name="Tascini Anna Sofia" userId="813f6bb4-81f2-4424-b468-a0a8a3b22e60" providerId="ADAL" clId="{5639AF44-58AE-6C4F-8FFA-A1423405AB76}" dt="2024-10-23T16:30:28.228" v="552" actId="2696"/>
        <pc:sldMkLst>
          <pc:docMk/>
          <pc:sldMk cId="1325698237" sldId="267"/>
        </pc:sldMkLst>
        <pc:spChg chg="add mod">
          <ac:chgData name="Tascini Anna Sofia" userId="813f6bb4-81f2-4424-b468-a0a8a3b22e60" providerId="ADAL" clId="{5639AF44-58AE-6C4F-8FFA-A1423405AB76}" dt="2024-10-17T15:44:50.329" v="269" actId="20577"/>
          <ac:spMkLst>
            <pc:docMk/>
            <pc:sldMk cId="1325698237" sldId="267"/>
            <ac:spMk id="2" creationId="{D2FD2DFC-1281-4B36-76CB-ED5BBF0E80B0}"/>
          </ac:spMkLst>
        </pc:spChg>
      </pc:sldChg>
      <pc:sldChg chg="addSp delSp modSp new mod ord modNotesTx">
        <pc:chgData name="Tascini Anna Sofia" userId="813f6bb4-81f2-4424-b468-a0a8a3b22e60" providerId="ADAL" clId="{5639AF44-58AE-6C4F-8FFA-A1423405AB76}" dt="2024-10-17T15:52:04.560" v="288" actId="20577"/>
        <pc:sldMkLst>
          <pc:docMk/>
          <pc:sldMk cId="105346452" sldId="268"/>
        </pc:sldMkLst>
        <pc:spChg chg="add del mod">
          <ac:chgData name="Tascini Anna Sofia" userId="813f6bb4-81f2-4424-b468-a0a8a3b22e60" providerId="ADAL" clId="{5639AF44-58AE-6C4F-8FFA-A1423405AB76}" dt="2024-10-17T15:44:04.701" v="253" actId="478"/>
          <ac:spMkLst>
            <pc:docMk/>
            <pc:sldMk cId="105346452" sldId="268"/>
            <ac:spMk id="4" creationId="{2CFF59F0-3311-9E7F-6BB4-85EE48A9C1EA}"/>
          </ac:spMkLst>
        </pc:spChg>
        <pc:spChg chg="add del mod">
          <ac:chgData name="Tascini Anna Sofia" userId="813f6bb4-81f2-4424-b468-a0a8a3b22e60" providerId="ADAL" clId="{5639AF44-58AE-6C4F-8FFA-A1423405AB76}" dt="2024-10-17T15:44:04.701" v="253" actId="478"/>
          <ac:spMkLst>
            <pc:docMk/>
            <pc:sldMk cId="105346452" sldId="268"/>
            <ac:spMk id="5" creationId="{1B84E153-4C66-1987-948D-93F256117CF4}"/>
          </ac:spMkLst>
        </pc:spChg>
        <pc:spChg chg="add del mod">
          <ac:chgData name="Tascini Anna Sofia" userId="813f6bb4-81f2-4424-b468-a0a8a3b22e60" providerId="ADAL" clId="{5639AF44-58AE-6C4F-8FFA-A1423405AB76}" dt="2024-10-17T15:44:16.858" v="256" actId="478"/>
          <ac:spMkLst>
            <pc:docMk/>
            <pc:sldMk cId="105346452" sldId="268"/>
            <ac:spMk id="6" creationId="{FAA24AE7-4BCA-8ABB-423B-1CA27447BCB4}"/>
          </ac:spMkLst>
        </pc:spChg>
        <pc:spChg chg="add del mod">
          <ac:chgData name="Tascini Anna Sofia" userId="813f6bb4-81f2-4424-b468-a0a8a3b22e60" providerId="ADAL" clId="{5639AF44-58AE-6C4F-8FFA-A1423405AB76}" dt="2024-10-17T15:44:28.801" v="258" actId="478"/>
          <ac:spMkLst>
            <pc:docMk/>
            <pc:sldMk cId="105346452" sldId="268"/>
            <ac:spMk id="7" creationId="{DD230345-FC1E-6664-A8AF-9382C0788919}"/>
          </ac:spMkLst>
        </pc:spChg>
        <pc:spChg chg="add mod">
          <ac:chgData name="Tascini Anna Sofia" userId="813f6bb4-81f2-4424-b468-a0a8a3b22e60" providerId="ADAL" clId="{5639AF44-58AE-6C4F-8FFA-A1423405AB76}" dt="2024-10-17T15:52:04.560" v="288" actId="20577"/>
          <ac:spMkLst>
            <pc:docMk/>
            <pc:sldMk cId="105346452" sldId="268"/>
            <ac:spMk id="8" creationId="{C9F978FA-F74E-01AB-2B3E-9EE2C0991337}"/>
          </ac:spMkLst>
        </pc:spChg>
        <pc:picChg chg="add mod">
          <ac:chgData name="Tascini Anna Sofia" userId="813f6bb4-81f2-4424-b468-a0a8a3b22e60" providerId="ADAL" clId="{5639AF44-58AE-6C4F-8FFA-A1423405AB76}" dt="2024-10-17T15:44:58.755" v="270" actId="14100"/>
          <ac:picMkLst>
            <pc:docMk/>
            <pc:sldMk cId="105346452" sldId="268"/>
            <ac:picMk id="2" creationId="{F09E897B-D346-DF02-C464-31508B7293C1}"/>
          </ac:picMkLst>
        </pc:picChg>
        <pc:picChg chg="add mod">
          <ac:chgData name="Tascini Anna Sofia" userId="813f6bb4-81f2-4424-b468-a0a8a3b22e60" providerId="ADAL" clId="{5639AF44-58AE-6C4F-8FFA-A1423405AB76}" dt="2024-10-17T15:43:53.930" v="250" actId="1076"/>
          <ac:picMkLst>
            <pc:docMk/>
            <pc:sldMk cId="105346452" sldId="268"/>
            <ac:picMk id="3" creationId="{A59E2CBD-D519-0443-287A-8F06BA4895BA}"/>
          </ac:picMkLst>
        </pc:picChg>
      </pc:sldChg>
      <pc:sldChg chg="addSp delSp modSp add mod">
        <pc:chgData name="Tascini Anna Sofia" userId="813f6bb4-81f2-4424-b468-a0a8a3b22e60" providerId="ADAL" clId="{5639AF44-58AE-6C4F-8FFA-A1423405AB76}" dt="2024-10-23T16:30:34.400" v="557" actId="1076"/>
        <pc:sldMkLst>
          <pc:docMk/>
          <pc:sldMk cId="2835637795" sldId="269"/>
        </pc:sldMkLst>
        <pc:spChg chg="mod">
          <ac:chgData name="Tascini Anna Sofia" userId="813f6bb4-81f2-4424-b468-a0a8a3b22e60" providerId="ADAL" clId="{5639AF44-58AE-6C4F-8FFA-A1423405AB76}" dt="2024-10-23T16:30:34.400" v="557" actId="1076"/>
          <ac:spMkLst>
            <pc:docMk/>
            <pc:sldMk cId="2835637795" sldId="269"/>
            <ac:spMk id="2" creationId="{D2FD2DFC-1281-4B36-76CB-ED5BBF0E80B0}"/>
          </ac:spMkLst>
        </pc:spChg>
        <pc:spChg chg="add del mod">
          <ac:chgData name="Tascini Anna Sofia" userId="813f6bb4-81f2-4424-b468-a0a8a3b22e60" providerId="ADAL" clId="{5639AF44-58AE-6C4F-8FFA-A1423405AB76}" dt="2024-10-23T08:07:11.496" v="307"/>
          <ac:spMkLst>
            <pc:docMk/>
            <pc:sldMk cId="2835637795" sldId="269"/>
            <ac:spMk id="5" creationId="{5D44E8AF-AD00-1D02-8B59-DFA57D4E8A84}"/>
          </ac:spMkLst>
        </pc:spChg>
        <pc:spChg chg="mod">
          <ac:chgData name="Tascini Anna Sofia" userId="813f6bb4-81f2-4424-b468-a0a8a3b22e60" providerId="ADAL" clId="{5639AF44-58AE-6C4F-8FFA-A1423405AB76}" dt="2024-10-23T09:17:32.431" v="483" actId="1035"/>
          <ac:spMkLst>
            <pc:docMk/>
            <pc:sldMk cId="2835637795" sldId="269"/>
            <ac:spMk id="10" creationId="{CE834D75-7840-3741-AF58-73ED76BB3CA2}"/>
          </ac:spMkLst>
        </pc:spChg>
        <pc:spChg chg="mod">
          <ac:chgData name="Tascini Anna Sofia" userId="813f6bb4-81f2-4424-b468-a0a8a3b22e60" providerId="ADAL" clId="{5639AF44-58AE-6C4F-8FFA-A1423405AB76}" dt="2024-10-23T09:17:32.431" v="483" actId="1035"/>
          <ac:spMkLst>
            <pc:docMk/>
            <pc:sldMk cId="2835637795" sldId="269"/>
            <ac:spMk id="11" creationId="{DF41D39C-B09E-2146-8633-A10568B797AA}"/>
          </ac:spMkLst>
        </pc:spChg>
        <pc:spChg chg="mod">
          <ac:chgData name="Tascini Anna Sofia" userId="813f6bb4-81f2-4424-b468-a0a8a3b22e60" providerId="ADAL" clId="{5639AF44-58AE-6C4F-8FFA-A1423405AB76}" dt="2024-10-23T09:17:47.737" v="489" actId="12789"/>
          <ac:spMkLst>
            <pc:docMk/>
            <pc:sldMk cId="2835637795" sldId="269"/>
            <ac:spMk id="14" creationId="{D9525008-BE3A-B34C-8331-A546762E09FD}"/>
          </ac:spMkLst>
        </pc:spChg>
        <pc:spChg chg="mod">
          <ac:chgData name="Tascini Anna Sofia" userId="813f6bb4-81f2-4424-b468-a0a8a3b22e60" providerId="ADAL" clId="{5639AF44-58AE-6C4F-8FFA-A1423405AB76}" dt="2024-10-23T09:17:57.031" v="490" actId="12789"/>
          <ac:spMkLst>
            <pc:docMk/>
            <pc:sldMk cId="2835637795" sldId="269"/>
            <ac:spMk id="15" creationId="{576FACDB-F556-F348-988E-94A2AE136D95}"/>
          </ac:spMkLst>
        </pc:spChg>
        <pc:spChg chg="mod">
          <ac:chgData name="Tascini Anna Sofia" userId="813f6bb4-81f2-4424-b468-a0a8a3b22e60" providerId="ADAL" clId="{5639AF44-58AE-6C4F-8FFA-A1423405AB76}" dt="2024-10-23T09:17:47.737" v="489" actId="12789"/>
          <ac:spMkLst>
            <pc:docMk/>
            <pc:sldMk cId="2835637795" sldId="269"/>
            <ac:spMk id="16" creationId="{FBB8538B-902D-9B40-AA8F-A73C81D6E79E}"/>
          </ac:spMkLst>
        </pc:spChg>
        <pc:spChg chg="mod">
          <ac:chgData name="Tascini Anna Sofia" userId="813f6bb4-81f2-4424-b468-a0a8a3b22e60" providerId="ADAL" clId="{5639AF44-58AE-6C4F-8FFA-A1423405AB76}" dt="2024-10-23T09:17:57.031" v="490" actId="12789"/>
          <ac:spMkLst>
            <pc:docMk/>
            <pc:sldMk cId="2835637795" sldId="269"/>
            <ac:spMk id="17" creationId="{278AA096-EAE8-0142-8015-CCD7FBDF1AB2}"/>
          </ac:spMkLst>
        </pc:spChg>
        <pc:spChg chg="add">
          <ac:chgData name="Tascini Anna Sofia" userId="813f6bb4-81f2-4424-b468-a0a8a3b22e60" providerId="ADAL" clId="{5639AF44-58AE-6C4F-8FFA-A1423405AB76}" dt="2024-10-23T09:12:03.772" v="430"/>
          <ac:spMkLst>
            <pc:docMk/>
            <pc:sldMk cId="2835637795" sldId="269"/>
            <ac:spMk id="22" creationId="{DE54AE53-6703-E8A2-0D2C-959FC4A1637D}"/>
          </ac:spMkLst>
        </pc:spChg>
        <pc:spChg chg="add mod">
          <ac:chgData name="Tascini Anna Sofia" userId="813f6bb4-81f2-4424-b468-a0a8a3b22e60" providerId="ADAL" clId="{5639AF44-58AE-6C4F-8FFA-A1423405AB76}" dt="2024-10-23T09:12:50.756" v="442" actId="403"/>
          <ac:spMkLst>
            <pc:docMk/>
            <pc:sldMk cId="2835637795" sldId="269"/>
            <ac:spMk id="29" creationId="{C31556D3-F536-0683-24AF-7EAF556E942A}"/>
          </ac:spMkLst>
        </pc:spChg>
        <pc:spChg chg="add mod">
          <ac:chgData name="Tascini Anna Sofia" userId="813f6bb4-81f2-4424-b468-a0a8a3b22e60" providerId="ADAL" clId="{5639AF44-58AE-6C4F-8FFA-A1423405AB76}" dt="2024-10-23T09:13:00.113" v="444" actId="1076"/>
          <ac:spMkLst>
            <pc:docMk/>
            <pc:sldMk cId="2835637795" sldId="269"/>
            <ac:spMk id="30" creationId="{8003724A-229C-77B8-EE5F-D0F91B56EAD1}"/>
          </ac:spMkLst>
        </pc:spChg>
        <pc:spChg chg="add mod">
          <ac:chgData name="Tascini Anna Sofia" userId="813f6bb4-81f2-4424-b468-a0a8a3b22e60" providerId="ADAL" clId="{5639AF44-58AE-6C4F-8FFA-A1423405AB76}" dt="2024-10-23T09:13:02.361" v="445" actId="1076"/>
          <ac:spMkLst>
            <pc:docMk/>
            <pc:sldMk cId="2835637795" sldId="269"/>
            <ac:spMk id="31" creationId="{670EEBB7-A9D1-C0DB-59CE-EA2AA685A048}"/>
          </ac:spMkLst>
        </pc:spChg>
        <pc:spChg chg="del mod">
          <ac:chgData name="Tascini Anna Sofia" userId="813f6bb4-81f2-4424-b468-a0a8a3b22e60" providerId="ADAL" clId="{5639AF44-58AE-6C4F-8FFA-A1423405AB76}" dt="2024-10-23T08:42:48.825" v="403" actId="478"/>
          <ac:spMkLst>
            <pc:docMk/>
            <pc:sldMk cId="2835637795" sldId="269"/>
            <ac:spMk id="39" creationId="{8E1CF4CF-6044-8B45-96FA-376FE11DE633}"/>
          </ac:spMkLst>
        </pc:spChg>
        <pc:spChg chg="mod">
          <ac:chgData name="Tascini Anna Sofia" userId="813f6bb4-81f2-4424-b468-a0a8a3b22e60" providerId="ADAL" clId="{5639AF44-58AE-6C4F-8FFA-A1423405AB76}" dt="2024-10-23T08:07:09.333" v="305" actId="1076"/>
          <ac:spMkLst>
            <pc:docMk/>
            <pc:sldMk cId="2835637795" sldId="269"/>
            <ac:spMk id="40" creationId="{8805FCA2-7844-944F-94DB-7884E49D1B10}"/>
          </ac:spMkLst>
        </pc:spChg>
        <pc:spChg chg="mod">
          <ac:chgData name="Tascini Anna Sofia" userId="813f6bb4-81f2-4424-b468-a0a8a3b22e60" providerId="ADAL" clId="{5639AF44-58AE-6C4F-8FFA-A1423405AB76}" dt="2024-10-23T08:07:09.333" v="305" actId="1076"/>
          <ac:spMkLst>
            <pc:docMk/>
            <pc:sldMk cId="2835637795" sldId="269"/>
            <ac:spMk id="46" creationId="{0389A31D-0629-4441-A5ED-ADAB98856D5C}"/>
          </ac:spMkLst>
        </pc:spChg>
        <pc:spChg chg="del mod">
          <ac:chgData name="Tascini Anna Sofia" userId="813f6bb4-81f2-4424-b468-a0a8a3b22e60" providerId="ADAL" clId="{5639AF44-58AE-6C4F-8FFA-A1423405AB76}" dt="2024-10-23T08:40:49.686" v="395" actId="478"/>
          <ac:spMkLst>
            <pc:docMk/>
            <pc:sldMk cId="2835637795" sldId="269"/>
            <ac:spMk id="47" creationId="{E7DCAC98-40CA-004F-83C0-09113C873381}"/>
          </ac:spMkLst>
        </pc:spChg>
        <pc:spChg chg="mod">
          <ac:chgData name="Tascini Anna Sofia" userId="813f6bb4-81f2-4424-b468-a0a8a3b22e60" providerId="ADAL" clId="{5639AF44-58AE-6C4F-8FFA-A1423405AB76}" dt="2024-10-23T16:29:56.708" v="551" actId="20577"/>
          <ac:spMkLst>
            <pc:docMk/>
            <pc:sldMk cId="2835637795" sldId="269"/>
            <ac:spMk id="50" creationId="{6B02632C-9FB4-A442-858D-5CAD4C0997A2}"/>
          </ac:spMkLst>
        </pc:spChg>
        <pc:spChg chg="mod">
          <ac:chgData name="Tascini Anna Sofia" userId="813f6bb4-81f2-4424-b468-a0a8a3b22e60" providerId="ADAL" clId="{5639AF44-58AE-6C4F-8FFA-A1423405AB76}" dt="2024-10-23T08:07:09.333" v="305" actId="1076"/>
          <ac:spMkLst>
            <pc:docMk/>
            <pc:sldMk cId="2835637795" sldId="269"/>
            <ac:spMk id="51" creationId="{BD29801C-F5A4-5C44-8299-8BB817192887}"/>
          </ac:spMkLst>
        </pc:spChg>
        <pc:spChg chg="del mod">
          <ac:chgData name="Tascini Anna Sofia" userId="813f6bb4-81f2-4424-b468-a0a8a3b22e60" providerId="ADAL" clId="{5639AF44-58AE-6C4F-8FFA-A1423405AB76}" dt="2024-10-23T08:51:30.246" v="422" actId="478"/>
          <ac:spMkLst>
            <pc:docMk/>
            <pc:sldMk cId="2835637795" sldId="269"/>
            <ac:spMk id="52" creationId="{BF2C9BAB-874D-F84D-AF46-43F560E30655}"/>
          </ac:spMkLst>
        </pc:spChg>
        <pc:spChg chg="del mod">
          <ac:chgData name="Tascini Anna Sofia" userId="813f6bb4-81f2-4424-b468-a0a8a3b22e60" providerId="ADAL" clId="{5639AF44-58AE-6C4F-8FFA-A1423405AB76}" dt="2024-10-23T16:28:34.204" v="506" actId="478"/>
          <ac:spMkLst>
            <pc:docMk/>
            <pc:sldMk cId="2835637795" sldId="269"/>
            <ac:spMk id="53" creationId="{F96FF8B6-81C5-4546-B186-EF48C0D7FB55}"/>
          </ac:spMkLst>
        </pc:spChg>
        <pc:spChg chg="mod">
          <ac:chgData name="Tascini Anna Sofia" userId="813f6bb4-81f2-4424-b468-a0a8a3b22e60" providerId="ADAL" clId="{5639AF44-58AE-6C4F-8FFA-A1423405AB76}" dt="2024-10-23T08:07:09.333" v="305" actId="1076"/>
          <ac:spMkLst>
            <pc:docMk/>
            <pc:sldMk cId="2835637795" sldId="269"/>
            <ac:spMk id="56" creationId="{3669A6E7-6E12-6447-9EBD-E48F4DE62557}"/>
          </ac:spMkLst>
        </pc:spChg>
        <pc:grpChg chg="add del mod">
          <ac:chgData name="Tascini Anna Sofia" userId="813f6bb4-81f2-4424-b468-a0a8a3b22e60" providerId="ADAL" clId="{5639AF44-58AE-6C4F-8FFA-A1423405AB76}" dt="2024-10-23T09:12:03.428" v="429" actId="478"/>
          <ac:grpSpMkLst>
            <pc:docMk/>
            <pc:sldMk cId="2835637795" sldId="269"/>
            <ac:grpSpMk id="3" creationId="{463EB574-9099-490A-2F2D-FD9C8637B03F}"/>
          </ac:grpSpMkLst>
        </pc:grpChg>
        <pc:picChg chg="add mod">
          <ac:chgData name="Tascini Anna Sofia" userId="813f6bb4-81f2-4424-b468-a0a8a3b22e60" providerId="ADAL" clId="{5639AF44-58AE-6C4F-8FFA-A1423405AB76}" dt="2024-10-23T16:29:25.914" v="514" actId="1035"/>
          <ac:picMkLst>
            <pc:docMk/>
            <pc:sldMk cId="2835637795" sldId="269"/>
            <ac:picMk id="4" creationId="{0E1C23B8-9870-49E8-BCE5-3A914FE97580}"/>
          </ac:picMkLst>
        </pc:picChg>
        <pc:picChg chg="del mod">
          <ac:chgData name="Tascini Anna Sofia" userId="813f6bb4-81f2-4424-b468-a0a8a3b22e60" providerId="ADAL" clId="{5639AF44-58AE-6C4F-8FFA-A1423405AB76}" dt="2024-10-23T09:16:02.291" v="454" actId="478"/>
          <ac:picMkLst>
            <pc:docMk/>
            <pc:sldMk cId="2835637795" sldId="269"/>
            <ac:picMk id="4" creationId="{1987046F-10EE-9C4A-9D8F-27BA80ED0E4A}"/>
          </ac:picMkLst>
        </pc:picChg>
        <pc:picChg chg="mod modCrop">
          <ac:chgData name="Tascini Anna Sofia" userId="813f6bb4-81f2-4424-b468-a0a8a3b22e60" providerId="ADAL" clId="{5639AF44-58AE-6C4F-8FFA-A1423405AB76}" dt="2024-10-23T09:16:07.355" v="456" actId="1076"/>
          <ac:picMkLst>
            <pc:docMk/>
            <pc:sldMk cId="2835637795" sldId="269"/>
            <ac:picMk id="7" creationId="{B41EF0D0-C182-E84F-AEBB-21B1213EC9EE}"/>
          </ac:picMkLst>
        </pc:picChg>
        <pc:picChg chg="add mod">
          <ac:chgData name="Tascini Anna Sofia" userId="813f6bb4-81f2-4424-b468-a0a8a3b22e60" providerId="ADAL" clId="{5639AF44-58AE-6C4F-8FFA-A1423405AB76}" dt="2024-10-23T09:18:09.904" v="493" actId="1038"/>
          <ac:picMkLst>
            <pc:docMk/>
            <pc:sldMk cId="2835637795" sldId="269"/>
            <ac:picMk id="12" creationId="{8E9BFB8D-7230-7415-846D-089FDF3E81A7}"/>
          </ac:picMkLst>
        </pc:picChg>
        <pc:picChg chg="del">
          <ac:chgData name="Tascini Anna Sofia" userId="813f6bb4-81f2-4424-b468-a0a8a3b22e60" providerId="ADAL" clId="{5639AF44-58AE-6C4F-8FFA-A1423405AB76}" dt="2024-10-23T16:28:31.774" v="505" actId="478"/>
          <ac:picMkLst>
            <pc:docMk/>
            <pc:sldMk cId="2835637795" sldId="269"/>
            <ac:picMk id="13" creationId="{138B80D6-C757-E9CE-4236-29677449AB18}"/>
          </ac:picMkLst>
        </pc:picChg>
        <pc:picChg chg="add mod">
          <ac:chgData name="Tascini Anna Sofia" userId="813f6bb4-81f2-4424-b468-a0a8a3b22e60" providerId="ADAL" clId="{5639AF44-58AE-6C4F-8FFA-A1423405AB76}" dt="2024-10-23T08:44:30.548" v="421" actId="1035"/>
          <ac:picMkLst>
            <pc:docMk/>
            <pc:sldMk cId="2835637795" sldId="269"/>
            <ac:picMk id="18" creationId="{3C76B2DC-920A-69B6-836B-496E12039A65}"/>
          </ac:picMkLst>
        </pc:picChg>
        <pc:picChg chg="add mod">
          <ac:chgData name="Tascini Anna Sofia" userId="813f6bb4-81f2-4424-b468-a0a8a3b22e60" providerId="ADAL" clId="{5639AF44-58AE-6C4F-8FFA-A1423405AB76}" dt="2024-10-23T16:29:25.914" v="514" actId="1035"/>
          <ac:picMkLst>
            <pc:docMk/>
            <pc:sldMk cId="2835637795" sldId="269"/>
            <ac:picMk id="20" creationId="{E186E5FE-5CF4-0CFA-682D-BF1D876F83B6}"/>
          </ac:picMkLst>
        </pc:picChg>
        <pc:picChg chg="mod">
          <ac:chgData name="Tascini Anna Sofia" userId="813f6bb4-81f2-4424-b468-a0a8a3b22e60" providerId="ADAL" clId="{5639AF44-58AE-6C4F-8FFA-A1423405AB76}" dt="2024-10-23T08:07:57.438" v="319" actId="1076"/>
          <ac:picMkLst>
            <pc:docMk/>
            <pc:sldMk cId="2835637795" sldId="269"/>
            <ac:picMk id="21" creationId="{2115BC81-3BB0-F84C-82A0-4353B73BB06A}"/>
          </ac:picMkLst>
        </pc:picChg>
        <pc:picChg chg="mod">
          <ac:chgData name="Tascini Anna Sofia" userId="813f6bb4-81f2-4424-b468-a0a8a3b22e60" providerId="ADAL" clId="{5639AF44-58AE-6C4F-8FFA-A1423405AB76}" dt="2024-10-23T08:06:27.337" v="297" actId="1076"/>
          <ac:picMkLst>
            <pc:docMk/>
            <pc:sldMk cId="2835637795" sldId="269"/>
            <ac:picMk id="23" creationId="{A39AECB8-7623-7B43-ADCB-945105CE54AD}"/>
          </ac:picMkLst>
        </pc:picChg>
        <pc:picChg chg="add mod">
          <ac:chgData name="Tascini Anna Sofia" userId="813f6bb4-81f2-4424-b468-a0a8a3b22e60" providerId="ADAL" clId="{5639AF44-58AE-6C4F-8FFA-A1423405AB76}" dt="2024-10-23T09:12:30.760" v="438" actId="1076"/>
          <ac:picMkLst>
            <pc:docMk/>
            <pc:sldMk cId="2835637795" sldId="269"/>
            <ac:picMk id="28" creationId="{926C3434-2F77-FA3C-2611-1C414283AF98}"/>
          </ac:picMkLst>
        </pc:picChg>
        <pc:picChg chg="add mod">
          <ac:chgData name="Tascini Anna Sofia" userId="813f6bb4-81f2-4424-b468-a0a8a3b22e60" providerId="ADAL" clId="{5639AF44-58AE-6C4F-8FFA-A1423405AB76}" dt="2024-10-23T09:16:48.828" v="475" actId="1076"/>
          <ac:picMkLst>
            <pc:docMk/>
            <pc:sldMk cId="2835637795" sldId="269"/>
            <ac:picMk id="33" creationId="{EA0C5E68-EF8B-2BA5-C5C2-69644C65E34B}"/>
          </ac:picMkLst>
        </pc:picChg>
        <pc:picChg chg="del mod">
          <ac:chgData name="Tascini Anna Sofia" userId="813f6bb4-81f2-4424-b468-a0a8a3b22e60" providerId="ADAL" clId="{5639AF44-58AE-6C4F-8FFA-A1423405AB76}" dt="2024-10-23T08:42:46.506" v="402" actId="478"/>
          <ac:picMkLst>
            <pc:docMk/>
            <pc:sldMk cId="2835637795" sldId="269"/>
            <ac:picMk id="38" creationId="{FC45419D-1D41-DD47-AF03-AD9349117D6F}"/>
          </ac:picMkLst>
        </pc:picChg>
        <pc:picChg chg="del mod">
          <ac:chgData name="Tascini Anna Sofia" userId="813f6bb4-81f2-4424-b468-a0a8a3b22e60" providerId="ADAL" clId="{5639AF44-58AE-6C4F-8FFA-A1423405AB76}" dt="2024-10-23T08:40:32.015" v="388" actId="478"/>
          <ac:picMkLst>
            <pc:docMk/>
            <pc:sldMk cId="2835637795" sldId="269"/>
            <ac:picMk id="43" creationId="{D07B2BE9-D929-AF45-82C1-3AA060F31F9B}"/>
          </ac:picMkLst>
        </pc:picChg>
        <pc:picChg chg="mod">
          <ac:chgData name="Tascini Anna Sofia" userId="813f6bb4-81f2-4424-b468-a0a8a3b22e60" providerId="ADAL" clId="{5639AF44-58AE-6C4F-8FFA-A1423405AB76}" dt="2024-10-23T09:18:17.708" v="494" actId="1076"/>
          <ac:picMkLst>
            <pc:docMk/>
            <pc:sldMk cId="2835637795" sldId="269"/>
            <ac:picMk id="55" creationId="{9BB0282B-5570-F840-BB6D-F266580E6056}"/>
          </ac:picMkLst>
        </pc:picChg>
        <pc:picChg chg="del mod">
          <ac:chgData name="Tascini Anna Sofia" userId="813f6bb4-81f2-4424-b468-a0a8a3b22e60" providerId="ADAL" clId="{5639AF44-58AE-6C4F-8FFA-A1423405AB76}" dt="2024-10-23T08:51:30.246" v="422" actId="478"/>
          <ac:picMkLst>
            <pc:docMk/>
            <pc:sldMk cId="2835637795" sldId="269"/>
            <ac:picMk id="60" creationId="{3BBA9F5E-1CBF-CE42-816F-95C6ADB1B17F}"/>
          </ac:picMkLst>
        </pc:picChg>
      </pc:sldChg>
    </pc:docChg>
  </pc:docChgLst>
  <pc:docChgLst>
    <pc:chgData name="MAURIZIO AURORA" userId="2e4518e9-735f-400a-98c7-f8014a7e3fcf" providerId="ADAL" clId="{2117C0FC-09D9-AA44-AFDF-172D540D6279}"/>
    <pc:docChg chg="undo custSel modSld">
      <pc:chgData name="MAURIZIO AURORA" userId="2e4518e9-735f-400a-98c7-f8014a7e3fcf" providerId="ADAL" clId="{2117C0FC-09D9-AA44-AFDF-172D540D6279}" dt="2024-10-19T17:34:49.393" v="1045" actId="1076"/>
      <pc:docMkLst>
        <pc:docMk/>
      </pc:docMkLst>
      <pc:sldChg chg="modSp mod">
        <pc:chgData name="MAURIZIO AURORA" userId="2e4518e9-735f-400a-98c7-f8014a7e3fcf" providerId="ADAL" clId="{2117C0FC-09D9-AA44-AFDF-172D540D6279}" dt="2024-10-18T06:04:05.036" v="401" actId="255"/>
        <pc:sldMkLst>
          <pc:docMk/>
          <pc:sldMk cId="629443125" sldId="260"/>
        </pc:sldMkLst>
        <pc:spChg chg="mod">
          <ac:chgData name="MAURIZIO AURORA" userId="2e4518e9-735f-400a-98c7-f8014a7e3fcf" providerId="ADAL" clId="{2117C0FC-09D9-AA44-AFDF-172D540D6279}" dt="2024-10-18T06:03:58.536" v="400" actId="255"/>
          <ac:spMkLst>
            <pc:docMk/>
            <pc:sldMk cId="629443125" sldId="260"/>
            <ac:spMk id="12" creationId="{A3A6C9B3-5297-1FFD-0B15-1376270D46F9}"/>
          </ac:spMkLst>
        </pc:spChg>
        <pc:spChg chg="mod">
          <ac:chgData name="MAURIZIO AURORA" userId="2e4518e9-735f-400a-98c7-f8014a7e3fcf" providerId="ADAL" clId="{2117C0FC-09D9-AA44-AFDF-172D540D6279}" dt="2024-10-18T06:04:05.036" v="401" actId="255"/>
          <ac:spMkLst>
            <pc:docMk/>
            <pc:sldMk cId="629443125" sldId="260"/>
            <ac:spMk id="16" creationId="{2FF5EAE8-2B45-FA50-B860-F138A1DDC7B8}"/>
          </ac:spMkLst>
        </pc:spChg>
      </pc:sldChg>
      <pc:sldChg chg="modSp mod">
        <pc:chgData name="MAURIZIO AURORA" userId="2e4518e9-735f-400a-98c7-f8014a7e3fcf" providerId="ADAL" clId="{2117C0FC-09D9-AA44-AFDF-172D540D6279}" dt="2024-10-18T06:03:22.184" v="397" actId="255"/>
        <pc:sldMkLst>
          <pc:docMk/>
          <pc:sldMk cId="867644236" sldId="262"/>
        </pc:sldMkLst>
        <pc:spChg chg="mod">
          <ac:chgData name="MAURIZIO AURORA" userId="2e4518e9-735f-400a-98c7-f8014a7e3fcf" providerId="ADAL" clId="{2117C0FC-09D9-AA44-AFDF-172D540D6279}" dt="2024-10-18T06:02:45.586" v="393" actId="255"/>
          <ac:spMkLst>
            <pc:docMk/>
            <pc:sldMk cId="867644236" sldId="262"/>
            <ac:spMk id="17" creationId="{49BA4904-8C3F-9942-8AAB-CF59AB117A93}"/>
          </ac:spMkLst>
        </pc:spChg>
        <pc:spChg chg="mod">
          <ac:chgData name="MAURIZIO AURORA" userId="2e4518e9-735f-400a-98c7-f8014a7e3fcf" providerId="ADAL" clId="{2117C0FC-09D9-AA44-AFDF-172D540D6279}" dt="2024-10-18T06:02:58.735" v="394" actId="255"/>
          <ac:spMkLst>
            <pc:docMk/>
            <pc:sldMk cId="867644236" sldId="262"/>
            <ac:spMk id="20" creationId="{0418A174-E9A4-CB5E-81B3-8F5630BECDE2}"/>
          </ac:spMkLst>
        </pc:spChg>
        <pc:spChg chg="mod">
          <ac:chgData name="MAURIZIO AURORA" userId="2e4518e9-735f-400a-98c7-f8014a7e3fcf" providerId="ADAL" clId="{2117C0FC-09D9-AA44-AFDF-172D540D6279}" dt="2024-10-18T06:03:22.184" v="397" actId="255"/>
          <ac:spMkLst>
            <pc:docMk/>
            <pc:sldMk cId="867644236" sldId="262"/>
            <ac:spMk id="24" creationId="{3716ED3D-D78C-7210-D727-48CB3FACD584}"/>
          </ac:spMkLst>
        </pc:spChg>
        <pc:spChg chg="mod">
          <ac:chgData name="MAURIZIO AURORA" userId="2e4518e9-735f-400a-98c7-f8014a7e3fcf" providerId="ADAL" clId="{2117C0FC-09D9-AA44-AFDF-172D540D6279}" dt="2024-10-18T06:03:15.485" v="396" actId="255"/>
          <ac:spMkLst>
            <pc:docMk/>
            <pc:sldMk cId="867644236" sldId="262"/>
            <ac:spMk id="25" creationId="{9C39A8AC-53DA-81AE-3CF0-91F050C60C9B}"/>
          </ac:spMkLst>
        </pc:spChg>
      </pc:sldChg>
      <pc:sldChg chg="modSp mod">
        <pc:chgData name="MAURIZIO AURORA" userId="2e4518e9-735f-400a-98c7-f8014a7e3fcf" providerId="ADAL" clId="{2117C0FC-09D9-AA44-AFDF-172D540D6279}" dt="2024-10-18T06:03:46.768" v="399" actId="255"/>
        <pc:sldMkLst>
          <pc:docMk/>
          <pc:sldMk cId="3866903768" sldId="265"/>
        </pc:sldMkLst>
        <pc:spChg chg="mod">
          <ac:chgData name="MAURIZIO AURORA" userId="2e4518e9-735f-400a-98c7-f8014a7e3fcf" providerId="ADAL" clId="{2117C0FC-09D9-AA44-AFDF-172D540D6279}" dt="2024-10-18T06:03:42.035" v="398" actId="255"/>
          <ac:spMkLst>
            <pc:docMk/>
            <pc:sldMk cId="3866903768" sldId="265"/>
            <ac:spMk id="5" creationId="{2F06DEF0-36AF-94D9-FB54-7A51E1354763}"/>
          </ac:spMkLst>
        </pc:spChg>
        <pc:spChg chg="mod">
          <ac:chgData name="MAURIZIO AURORA" userId="2e4518e9-735f-400a-98c7-f8014a7e3fcf" providerId="ADAL" clId="{2117C0FC-09D9-AA44-AFDF-172D540D6279}" dt="2024-10-18T06:03:46.768" v="399" actId="255"/>
          <ac:spMkLst>
            <pc:docMk/>
            <pc:sldMk cId="3866903768" sldId="265"/>
            <ac:spMk id="7" creationId="{EF5596EF-98E1-42B1-F62D-8768203C1B11}"/>
          </ac:spMkLst>
        </pc:spChg>
      </pc:sldChg>
      <pc:sldChg chg="addSp delSp modSp mod">
        <pc:chgData name="MAURIZIO AURORA" userId="2e4518e9-735f-400a-98c7-f8014a7e3fcf" providerId="ADAL" clId="{2117C0FC-09D9-AA44-AFDF-172D540D6279}" dt="2024-10-19T17:34:49.393" v="1045" actId="1076"/>
        <pc:sldMkLst>
          <pc:docMk/>
          <pc:sldMk cId="1325698237" sldId="267"/>
        </pc:sldMkLst>
        <pc:spChg chg="add del mod">
          <ac:chgData name="MAURIZIO AURORA" userId="2e4518e9-735f-400a-98c7-f8014a7e3fcf" providerId="ADAL" clId="{2117C0FC-09D9-AA44-AFDF-172D540D6279}" dt="2024-10-18T05:45:28.519" v="27" actId="767"/>
          <ac:spMkLst>
            <pc:docMk/>
            <pc:sldMk cId="1325698237" sldId="267"/>
            <ac:spMk id="9" creationId="{277F2379-465C-FB4D-BE98-2D14FA1C9E51}"/>
          </ac:spMkLst>
        </pc:spChg>
        <pc:spChg chg="add mod">
          <ac:chgData name="MAURIZIO AURORA" userId="2e4518e9-735f-400a-98c7-f8014a7e3fcf" providerId="ADAL" clId="{2117C0FC-09D9-AA44-AFDF-172D540D6279}" dt="2024-10-18T06:04:54.989" v="434" actId="1076"/>
          <ac:spMkLst>
            <pc:docMk/>
            <pc:sldMk cId="1325698237" sldId="267"/>
            <ac:spMk id="10" creationId="{CE834D75-7840-3741-AF58-73ED76BB3CA2}"/>
          </ac:spMkLst>
        </pc:spChg>
        <pc:spChg chg="add mod">
          <ac:chgData name="MAURIZIO AURORA" userId="2e4518e9-735f-400a-98c7-f8014a7e3fcf" providerId="ADAL" clId="{2117C0FC-09D9-AA44-AFDF-172D540D6279}" dt="2024-10-18T15:51:01.195" v="861" actId="20577"/>
          <ac:spMkLst>
            <pc:docMk/>
            <pc:sldMk cId="1325698237" sldId="267"/>
            <ac:spMk id="11" creationId="{DF41D39C-B09E-2146-8633-A10568B797AA}"/>
          </ac:spMkLst>
        </pc:spChg>
        <pc:spChg chg="add mod">
          <ac:chgData name="MAURIZIO AURORA" userId="2e4518e9-735f-400a-98c7-f8014a7e3fcf" providerId="ADAL" clId="{2117C0FC-09D9-AA44-AFDF-172D540D6279}" dt="2024-10-18T06:04:50.737" v="433" actId="1076"/>
          <ac:spMkLst>
            <pc:docMk/>
            <pc:sldMk cId="1325698237" sldId="267"/>
            <ac:spMk id="14" creationId="{D9525008-BE3A-B34C-8331-A546762E09FD}"/>
          </ac:spMkLst>
        </pc:spChg>
        <pc:spChg chg="add mod">
          <ac:chgData name="MAURIZIO AURORA" userId="2e4518e9-735f-400a-98c7-f8014a7e3fcf" providerId="ADAL" clId="{2117C0FC-09D9-AA44-AFDF-172D540D6279}" dt="2024-10-18T06:07:44.134" v="482" actId="1076"/>
          <ac:spMkLst>
            <pc:docMk/>
            <pc:sldMk cId="1325698237" sldId="267"/>
            <ac:spMk id="15" creationId="{576FACDB-F556-F348-988E-94A2AE136D95}"/>
          </ac:spMkLst>
        </pc:spChg>
        <pc:spChg chg="add mod">
          <ac:chgData name="MAURIZIO AURORA" userId="2e4518e9-735f-400a-98c7-f8014a7e3fcf" providerId="ADAL" clId="{2117C0FC-09D9-AA44-AFDF-172D540D6279}" dt="2024-10-18T15:50:45.222" v="849" actId="1076"/>
          <ac:spMkLst>
            <pc:docMk/>
            <pc:sldMk cId="1325698237" sldId="267"/>
            <ac:spMk id="16" creationId="{FBB8538B-902D-9B40-AA8F-A73C81D6E79E}"/>
          </ac:spMkLst>
        </pc:spChg>
        <pc:spChg chg="add mod">
          <ac:chgData name="MAURIZIO AURORA" userId="2e4518e9-735f-400a-98c7-f8014a7e3fcf" providerId="ADAL" clId="{2117C0FC-09D9-AA44-AFDF-172D540D6279}" dt="2024-10-18T15:50:45.222" v="849" actId="1076"/>
          <ac:spMkLst>
            <pc:docMk/>
            <pc:sldMk cId="1325698237" sldId="267"/>
            <ac:spMk id="17" creationId="{278AA096-EAE8-0142-8015-CCD7FBDF1AB2}"/>
          </ac:spMkLst>
        </pc:spChg>
        <pc:spChg chg="add mod">
          <ac:chgData name="MAURIZIO AURORA" userId="2e4518e9-735f-400a-98c7-f8014a7e3fcf" providerId="ADAL" clId="{2117C0FC-09D9-AA44-AFDF-172D540D6279}" dt="2024-10-18T15:58:06.761" v="984" actId="1076"/>
          <ac:spMkLst>
            <pc:docMk/>
            <pc:sldMk cId="1325698237" sldId="267"/>
            <ac:spMk id="24" creationId="{532977EC-EE65-874D-9E77-C907C7ADA353}"/>
          </ac:spMkLst>
        </pc:spChg>
        <pc:spChg chg="add mod">
          <ac:chgData name="MAURIZIO AURORA" userId="2e4518e9-735f-400a-98c7-f8014a7e3fcf" providerId="ADAL" clId="{2117C0FC-09D9-AA44-AFDF-172D540D6279}" dt="2024-10-18T15:58:11.768" v="986" actId="1076"/>
          <ac:spMkLst>
            <pc:docMk/>
            <pc:sldMk cId="1325698237" sldId="267"/>
            <ac:spMk id="25" creationId="{B0252FD6-A126-3544-BDE3-015A4F00B9F0}"/>
          </ac:spMkLst>
        </pc:spChg>
        <pc:spChg chg="add mod">
          <ac:chgData name="MAURIZIO AURORA" userId="2e4518e9-735f-400a-98c7-f8014a7e3fcf" providerId="ADAL" clId="{2117C0FC-09D9-AA44-AFDF-172D540D6279}" dt="2024-10-18T15:58:09.252" v="985" actId="1076"/>
          <ac:spMkLst>
            <pc:docMk/>
            <pc:sldMk cId="1325698237" sldId="267"/>
            <ac:spMk id="26" creationId="{7DE7AB9C-6A00-EA42-8023-0651EA10E9A2}"/>
          </ac:spMkLst>
        </pc:spChg>
        <pc:spChg chg="add del mod">
          <ac:chgData name="MAURIZIO AURORA" userId="2e4518e9-735f-400a-98c7-f8014a7e3fcf" providerId="ADAL" clId="{2117C0FC-09D9-AA44-AFDF-172D540D6279}" dt="2024-10-18T15:41:05.343" v="682"/>
          <ac:spMkLst>
            <pc:docMk/>
            <pc:sldMk cId="1325698237" sldId="267"/>
            <ac:spMk id="37" creationId="{C3504258-8EB9-7547-938F-6773B4B09AB3}"/>
          </ac:spMkLst>
        </pc:spChg>
        <pc:spChg chg="add mod">
          <ac:chgData name="MAURIZIO AURORA" userId="2e4518e9-735f-400a-98c7-f8014a7e3fcf" providerId="ADAL" clId="{2117C0FC-09D9-AA44-AFDF-172D540D6279}" dt="2024-10-18T15:51:28.275" v="875" actId="1076"/>
          <ac:spMkLst>
            <pc:docMk/>
            <pc:sldMk cId="1325698237" sldId="267"/>
            <ac:spMk id="39" creationId="{8E1CF4CF-6044-8B45-96FA-376FE11DE633}"/>
          </ac:spMkLst>
        </pc:spChg>
        <pc:spChg chg="add mod">
          <ac:chgData name="MAURIZIO AURORA" userId="2e4518e9-735f-400a-98c7-f8014a7e3fcf" providerId="ADAL" clId="{2117C0FC-09D9-AA44-AFDF-172D540D6279}" dt="2024-10-18T15:51:28.275" v="875" actId="1076"/>
          <ac:spMkLst>
            <pc:docMk/>
            <pc:sldMk cId="1325698237" sldId="267"/>
            <ac:spMk id="40" creationId="{8805FCA2-7844-944F-94DB-7884E49D1B10}"/>
          </ac:spMkLst>
        </pc:spChg>
        <pc:spChg chg="add mod">
          <ac:chgData name="MAURIZIO AURORA" userId="2e4518e9-735f-400a-98c7-f8014a7e3fcf" providerId="ADAL" clId="{2117C0FC-09D9-AA44-AFDF-172D540D6279}" dt="2024-10-19T17:34:49.393" v="1045" actId="1076"/>
          <ac:spMkLst>
            <pc:docMk/>
            <pc:sldMk cId="1325698237" sldId="267"/>
            <ac:spMk id="46" creationId="{0389A31D-0629-4441-A5ED-ADAB98856D5C}"/>
          </ac:spMkLst>
        </pc:spChg>
        <pc:spChg chg="add mod">
          <ac:chgData name="MAURIZIO AURORA" userId="2e4518e9-735f-400a-98c7-f8014a7e3fcf" providerId="ADAL" clId="{2117C0FC-09D9-AA44-AFDF-172D540D6279}" dt="2024-10-19T17:34:46.117" v="1044" actId="1076"/>
          <ac:spMkLst>
            <pc:docMk/>
            <pc:sldMk cId="1325698237" sldId="267"/>
            <ac:spMk id="47" creationId="{E7DCAC98-40CA-004F-83C0-09113C873381}"/>
          </ac:spMkLst>
        </pc:spChg>
        <pc:spChg chg="add mod">
          <ac:chgData name="MAURIZIO AURORA" userId="2e4518e9-735f-400a-98c7-f8014a7e3fcf" providerId="ADAL" clId="{2117C0FC-09D9-AA44-AFDF-172D540D6279}" dt="2024-10-18T15:59:41.016" v="1042" actId="20577"/>
          <ac:spMkLst>
            <pc:docMk/>
            <pc:sldMk cId="1325698237" sldId="267"/>
            <ac:spMk id="50" creationId="{6B02632C-9FB4-A442-858D-5CAD4C0997A2}"/>
          </ac:spMkLst>
        </pc:spChg>
        <pc:spChg chg="add mod">
          <ac:chgData name="MAURIZIO AURORA" userId="2e4518e9-735f-400a-98c7-f8014a7e3fcf" providerId="ADAL" clId="{2117C0FC-09D9-AA44-AFDF-172D540D6279}" dt="2024-10-18T15:59:03.749" v="1022" actId="1037"/>
          <ac:spMkLst>
            <pc:docMk/>
            <pc:sldMk cId="1325698237" sldId="267"/>
            <ac:spMk id="51" creationId="{BD29801C-F5A4-5C44-8299-8BB817192887}"/>
          </ac:spMkLst>
        </pc:spChg>
        <pc:spChg chg="add mod">
          <ac:chgData name="MAURIZIO AURORA" userId="2e4518e9-735f-400a-98c7-f8014a7e3fcf" providerId="ADAL" clId="{2117C0FC-09D9-AA44-AFDF-172D540D6279}" dt="2024-10-18T15:59:07.569" v="1029" actId="1037"/>
          <ac:spMkLst>
            <pc:docMk/>
            <pc:sldMk cId="1325698237" sldId="267"/>
            <ac:spMk id="52" creationId="{BF2C9BAB-874D-F84D-AF46-43F560E30655}"/>
          </ac:spMkLst>
        </pc:spChg>
        <pc:spChg chg="add mod">
          <ac:chgData name="MAURIZIO AURORA" userId="2e4518e9-735f-400a-98c7-f8014a7e3fcf" providerId="ADAL" clId="{2117C0FC-09D9-AA44-AFDF-172D540D6279}" dt="2024-10-18T15:59:11.838" v="1033" actId="1038"/>
          <ac:spMkLst>
            <pc:docMk/>
            <pc:sldMk cId="1325698237" sldId="267"/>
            <ac:spMk id="53" creationId="{F96FF8B6-81C5-4546-B186-EF48C0D7FB55}"/>
          </ac:spMkLst>
        </pc:spChg>
        <pc:spChg chg="add mod">
          <ac:chgData name="MAURIZIO AURORA" userId="2e4518e9-735f-400a-98c7-f8014a7e3fcf" providerId="ADAL" clId="{2117C0FC-09D9-AA44-AFDF-172D540D6279}" dt="2024-10-18T15:55:02.052" v="925" actId="1076"/>
          <ac:spMkLst>
            <pc:docMk/>
            <pc:sldMk cId="1325698237" sldId="267"/>
            <ac:spMk id="56" creationId="{3669A6E7-6E12-6447-9EBD-E48F4DE62557}"/>
          </ac:spMkLst>
        </pc:spChg>
        <pc:picChg chg="add mod">
          <ac:chgData name="MAURIZIO AURORA" userId="2e4518e9-735f-400a-98c7-f8014a7e3fcf" providerId="ADAL" clId="{2117C0FC-09D9-AA44-AFDF-172D540D6279}" dt="2024-10-18T15:50:45.222" v="849" actId="1076"/>
          <ac:picMkLst>
            <pc:docMk/>
            <pc:sldMk cId="1325698237" sldId="267"/>
            <ac:picMk id="4" creationId="{1987046F-10EE-9C4A-9D8F-27BA80ED0E4A}"/>
          </ac:picMkLst>
        </pc:picChg>
        <pc:picChg chg="add del mod">
          <ac:chgData name="MAURIZIO AURORA" userId="2e4518e9-735f-400a-98c7-f8014a7e3fcf" providerId="ADAL" clId="{2117C0FC-09D9-AA44-AFDF-172D540D6279}" dt="2024-10-18T05:42:27.415" v="1" actId="478"/>
          <ac:picMkLst>
            <pc:docMk/>
            <pc:sldMk cId="1325698237" sldId="267"/>
            <ac:picMk id="4" creationId="{78D67BA1-00B1-A446-9C35-C298CA60CED0}"/>
          </ac:picMkLst>
        </pc:picChg>
        <pc:picChg chg="add mod">
          <ac:chgData name="MAURIZIO AURORA" userId="2e4518e9-735f-400a-98c7-f8014a7e3fcf" providerId="ADAL" clId="{2117C0FC-09D9-AA44-AFDF-172D540D6279}" dt="2024-10-18T06:05:57.478" v="446" actId="1076"/>
          <ac:picMkLst>
            <pc:docMk/>
            <pc:sldMk cId="1325698237" sldId="267"/>
            <ac:picMk id="6" creationId="{70EF393F-8781-7E4B-99A5-3676CA5235E6}"/>
          </ac:picMkLst>
        </pc:picChg>
        <pc:picChg chg="add mod">
          <ac:chgData name="MAURIZIO AURORA" userId="2e4518e9-735f-400a-98c7-f8014a7e3fcf" providerId="ADAL" clId="{2117C0FC-09D9-AA44-AFDF-172D540D6279}" dt="2024-10-18T15:50:38.223" v="848" actId="1076"/>
          <ac:picMkLst>
            <pc:docMk/>
            <pc:sldMk cId="1325698237" sldId="267"/>
            <ac:picMk id="7" creationId="{B41EF0D0-C182-E84F-AEBB-21B1213EC9EE}"/>
          </ac:picMkLst>
        </pc:picChg>
        <pc:picChg chg="add mod modCrop">
          <ac:chgData name="MAURIZIO AURORA" userId="2e4518e9-735f-400a-98c7-f8014a7e3fcf" providerId="ADAL" clId="{2117C0FC-09D9-AA44-AFDF-172D540D6279}" dt="2024-10-18T06:11:49.289" v="491" actId="1076"/>
          <ac:picMkLst>
            <pc:docMk/>
            <pc:sldMk cId="1325698237" sldId="267"/>
            <ac:picMk id="8" creationId="{98F3418D-5563-CC4F-9C37-57CEA4DA27F8}"/>
          </ac:picMkLst>
        </pc:picChg>
        <pc:picChg chg="add del mod">
          <ac:chgData name="MAURIZIO AURORA" userId="2e4518e9-735f-400a-98c7-f8014a7e3fcf" providerId="ADAL" clId="{2117C0FC-09D9-AA44-AFDF-172D540D6279}" dt="2024-10-18T15:45:09.438" v="749" actId="478"/>
          <ac:picMkLst>
            <pc:docMk/>
            <pc:sldMk cId="1325698237" sldId="267"/>
            <ac:picMk id="12" creationId="{01E531F1-82B4-FD40-8D7F-57C17EF38028}"/>
          </ac:picMkLst>
        </pc:picChg>
        <pc:picChg chg="add del mod">
          <ac:chgData name="MAURIZIO AURORA" userId="2e4518e9-735f-400a-98c7-f8014a7e3fcf" providerId="ADAL" clId="{2117C0FC-09D9-AA44-AFDF-172D540D6279}" dt="2024-10-18T15:20:30.663" v="588" actId="478"/>
          <ac:picMkLst>
            <pc:docMk/>
            <pc:sldMk cId="1325698237" sldId="267"/>
            <ac:picMk id="13" creationId="{E8B6AFA0-DDF6-F94C-8609-9630C586565C}"/>
          </ac:picMkLst>
        </pc:picChg>
        <pc:picChg chg="add del mod">
          <ac:chgData name="MAURIZIO AURORA" userId="2e4518e9-735f-400a-98c7-f8014a7e3fcf" providerId="ADAL" clId="{2117C0FC-09D9-AA44-AFDF-172D540D6279}" dt="2024-10-18T15:20:30.663" v="588" actId="478"/>
          <ac:picMkLst>
            <pc:docMk/>
            <pc:sldMk cId="1325698237" sldId="267"/>
            <ac:picMk id="19" creationId="{957C5083-6617-3D45-891B-55F430335BBF}"/>
          </ac:picMkLst>
        </pc:picChg>
        <pc:picChg chg="add del mod">
          <ac:chgData name="MAURIZIO AURORA" userId="2e4518e9-735f-400a-98c7-f8014a7e3fcf" providerId="ADAL" clId="{2117C0FC-09D9-AA44-AFDF-172D540D6279}" dt="2024-10-18T15:29:50.382" v="617" actId="478"/>
          <ac:picMkLst>
            <pc:docMk/>
            <pc:sldMk cId="1325698237" sldId="267"/>
            <ac:picMk id="20" creationId="{7C6F3B41-D75B-3146-B758-58F7D621915D}"/>
          </ac:picMkLst>
        </pc:picChg>
        <pc:picChg chg="add mod modCrop">
          <ac:chgData name="MAURIZIO AURORA" userId="2e4518e9-735f-400a-98c7-f8014a7e3fcf" providerId="ADAL" clId="{2117C0FC-09D9-AA44-AFDF-172D540D6279}" dt="2024-10-18T15:50:38.223" v="848" actId="1076"/>
          <ac:picMkLst>
            <pc:docMk/>
            <pc:sldMk cId="1325698237" sldId="267"/>
            <ac:picMk id="21" creationId="{2115BC81-3BB0-F84C-82A0-4353B73BB06A}"/>
          </ac:picMkLst>
        </pc:picChg>
        <pc:picChg chg="add mod">
          <ac:chgData name="MAURIZIO AURORA" userId="2e4518e9-735f-400a-98c7-f8014a7e3fcf" providerId="ADAL" clId="{2117C0FC-09D9-AA44-AFDF-172D540D6279}" dt="2024-10-18T15:50:45.222" v="849" actId="1076"/>
          <ac:picMkLst>
            <pc:docMk/>
            <pc:sldMk cId="1325698237" sldId="267"/>
            <ac:picMk id="23" creationId="{A39AECB8-7623-7B43-ADCB-945105CE54AD}"/>
          </ac:picMkLst>
        </pc:picChg>
        <pc:picChg chg="add del mod">
          <ac:chgData name="MAURIZIO AURORA" userId="2e4518e9-735f-400a-98c7-f8014a7e3fcf" providerId="ADAL" clId="{2117C0FC-09D9-AA44-AFDF-172D540D6279}" dt="2024-10-18T15:32:30.235" v="622" actId="478"/>
          <ac:picMkLst>
            <pc:docMk/>
            <pc:sldMk cId="1325698237" sldId="267"/>
            <ac:picMk id="27" creationId="{245088DE-525E-DA45-B1B9-25D4D2D6EE57}"/>
          </ac:picMkLst>
        </pc:picChg>
        <pc:picChg chg="add del mod">
          <ac:chgData name="MAURIZIO AURORA" userId="2e4518e9-735f-400a-98c7-f8014a7e3fcf" providerId="ADAL" clId="{2117C0FC-09D9-AA44-AFDF-172D540D6279}" dt="2024-10-18T06:16:49.035" v="513" actId="478"/>
          <ac:picMkLst>
            <pc:docMk/>
            <pc:sldMk cId="1325698237" sldId="267"/>
            <ac:picMk id="28" creationId="{3FB2F4D9-CB63-C84D-9BBE-5CA521D08EB1}"/>
          </ac:picMkLst>
        </pc:picChg>
        <pc:picChg chg="add del mod">
          <ac:chgData name="MAURIZIO AURORA" userId="2e4518e9-735f-400a-98c7-f8014a7e3fcf" providerId="ADAL" clId="{2117C0FC-09D9-AA44-AFDF-172D540D6279}" dt="2024-10-18T15:39:42.778" v="673" actId="478"/>
          <ac:picMkLst>
            <pc:docMk/>
            <pc:sldMk cId="1325698237" sldId="267"/>
            <ac:picMk id="29" creationId="{79E0B397-970A-0047-A3DC-D1C056F2C315}"/>
          </ac:picMkLst>
        </pc:picChg>
        <pc:picChg chg="add del mod">
          <ac:chgData name="MAURIZIO AURORA" userId="2e4518e9-735f-400a-98c7-f8014a7e3fcf" providerId="ADAL" clId="{2117C0FC-09D9-AA44-AFDF-172D540D6279}" dt="2024-10-18T06:23:47.566" v="523" actId="478"/>
          <ac:picMkLst>
            <pc:docMk/>
            <pc:sldMk cId="1325698237" sldId="267"/>
            <ac:picMk id="30" creationId="{5C627827-1B0B-2146-A854-274ECB0B4FAD}"/>
          </ac:picMkLst>
        </pc:picChg>
        <pc:picChg chg="add del mod">
          <ac:chgData name="MAURIZIO AURORA" userId="2e4518e9-735f-400a-98c7-f8014a7e3fcf" providerId="ADAL" clId="{2117C0FC-09D9-AA44-AFDF-172D540D6279}" dt="2024-10-18T15:34:27.984" v="633" actId="478"/>
          <ac:picMkLst>
            <pc:docMk/>
            <pc:sldMk cId="1325698237" sldId="267"/>
            <ac:picMk id="31" creationId="{78B32F06-B3C1-F144-89AD-1C4BD073340F}"/>
          </ac:picMkLst>
        </pc:picChg>
        <pc:picChg chg="add del mod">
          <ac:chgData name="MAURIZIO AURORA" userId="2e4518e9-735f-400a-98c7-f8014a7e3fcf" providerId="ADAL" clId="{2117C0FC-09D9-AA44-AFDF-172D540D6279}" dt="2024-10-18T07:11:23.154" v="572" actId="478"/>
          <ac:picMkLst>
            <pc:docMk/>
            <pc:sldMk cId="1325698237" sldId="267"/>
            <ac:picMk id="32" creationId="{626C333D-FC9E-8347-B859-9025226AFFD5}"/>
          </ac:picMkLst>
        </pc:picChg>
        <pc:picChg chg="add del mod">
          <ac:chgData name="MAURIZIO AURORA" userId="2e4518e9-735f-400a-98c7-f8014a7e3fcf" providerId="ADAL" clId="{2117C0FC-09D9-AA44-AFDF-172D540D6279}" dt="2024-10-18T15:45:09.438" v="749" actId="478"/>
          <ac:picMkLst>
            <pc:docMk/>
            <pc:sldMk cId="1325698237" sldId="267"/>
            <ac:picMk id="33" creationId="{A2F672AC-EA61-7346-B826-960760FCA048}"/>
          </ac:picMkLst>
        </pc:picChg>
        <pc:picChg chg="add del mod">
          <ac:chgData name="MAURIZIO AURORA" userId="2e4518e9-735f-400a-98c7-f8014a7e3fcf" providerId="ADAL" clId="{2117C0FC-09D9-AA44-AFDF-172D540D6279}" dt="2024-10-18T15:31:12.289" v="618" actId="478"/>
          <ac:picMkLst>
            <pc:docMk/>
            <pc:sldMk cId="1325698237" sldId="267"/>
            <ac:picMk id="34" creationId="{3CBD4E3A-613A-5B4E-A89F-86EAD85E0FC6}"/>
          </ac:picMkLst>
        </pc:picChg>
        <pc:picChg chg="add del mod">
          <ac:chgData name="MAURIZIO AURORA" userId="2e4518e9-735f-400a-98c7-f8014a7e3fcf" providerId="ADAL" clId="{2117C0FC-09D9-AA44-AFDF-172D540D6279}" dt="2024-10-18T15:28:27.254" v="613" actId="478"/>
          <ac:picMkLst>
            <pc:docMk/>
            <pc:sldMk cId="1325698237" sldId="267"/>
            <ac:picMk id="36" creationId="{11E86847-7420-404F-AD4B-B974FF9FDAE5}"/>
          </ac:picMkLst>
        </pc:picChg>
        <pc:picChg chg="add del mod">
          <ac:chgData name="MAURIZIO AURORA" userId="2e4518e9-735f-400a-98c7-f8014a7e3fcf" providerId="ADAL" clId="{2117C0FC-09D9-AA44-AFDF-172D540D6279}" dt="2024-10-18T07:18:52.353" v="578" actId="478"/>
          <ac:picMkLst>
            <pc:docMk/>
            <pc:sldMk cId="1325698237" sldId="267"/>
            <ac:picMk id="38" creationId="{A4A3862E-B9A9-4147-8DE8-637DFEC40223}"/>
          </ac:picMkLst>
        </pc:picChg>
        <pc:picChg chg="add mod">
          <ac:chgData name="MAURIZIO AURORA" userId="2e4518e9-735f-400a-98c7-f8014a7e3fcf" providerId="ADAL" clId="{2117C0FC-09D9-AA44-AFDF-172D540D6279}" dt="2024-10-18T15:50:53.347" v="851" actId="1076"/>
          <ac:picMkLst>
            <pc:docMk/>
            <pc:sldMk cId="1325698237" sldId="267"/>
            <ac:picMk id="38" creationId="{FC45419D-1D41-DD47-AF03-AD9349117D6F}"/>
          </ac:picMkLst>
        </pc:picChg>
        <pc:picChg chg="add del mod">
          <ac:chgData name="MAURIZIO AURORA" userId="2e4518e9-735f-400a-98c7-f8014a7e3fcf" providerId="ADAL" clId="{2117C0FC-09D9-AA44-AFDF-172D540D6279}" dt="2024-10-18T07:19:46.010" v="583" actId="478"/>
          <ac:picMkLst>
            <pc:docMk/>
            <pc:sldMk cId="1325698237" sldId="267"/>
            <ac:picMk id="40" creationId="{94FD8673-9A5F-2E48-BDEA-F9DD48243FC7}"/>
          </ac:picMkLst>
        </pc:picChg>
        <pc:picChg chg="add del mod">
          <ac:chgData name="MAURIZIO AURORA" userId="2e4518e9-735f-400a-98c7-f8014a7e3fcf" providerId="ADAL" clId="{2117C0FC-09D9-AA44-AFDF-172D540D6279}" dt="2024-10-18T15:28:11.433" v="606" actId="478"/>
          <ac:picMkLst>
            <pc:docMk/>
            <pc:sldMk cId="1325698237" sldId="267"/>
            <ac:picMk id="42" creationId="{FAA05C96-EAD7-354A-917C-D97A1E8D19A1}"/>
          </ac:picMkLst>
        </pc:picChg>
        <pc:picChg chg="add mod">
          <ac:chgData name="MAURIZIO AURORA" userId="2e4518e9-735f-400a-98c7-f8014a7e3fcf" providerId="ADAL" clId="{2117C0FC-09D9-AA44-AFDF-172D540D6279}" dt="2024-10-19T17:34:42.510" v="1043" actId="14100"/>
          <ac:picMkLst>
            <pc:docMk/>
            <pc:sldMk cId="1325698237" sldId="267"/>
            <ac:picMk id="43" creationId="{D07B2BE9-D929-AF45-82C1-3AA060F31F9B}"/>
          </ac:picMkLst>
        </pc:picChg>
        <pc:picChg chg="add del mod">
          <ac:chgData name="MAURIZIO AURORA" userId="2e4518e9-735f-400a-98c7-f8014a7e3fcf" providerId="ADAL" clId="{2117C0FC-09D9-AA44-AFDF-172D540D6279}" dt="2024-10-18T15:46:11.807" v="763"/>
          <ac:picMkLst>
            <pc:docMk/>
            <pc:sldMk cId="1325698237" sldId="267"/>
            <ac:picMk id="45" creationId="{2C460CB2-7B57-7342-B59A-CE8783B42C41}"/>
          </ac:picMkLst>
        </pc:picChg>
        <pc:picChg chg="add del mod">
          <ac:chgData name="MAURIZIO AURORA" userId="2e4518e9-735f-400a-98c7-f8014a7e3fcf" providerId="ADAL" clId="{2117C0FC-09D9-AA44-AFDF-172D540D6279}" dt="2024-10-18T15:56:55.018" v="936" actId="478"/>
          <ac:picMkLst>
            <pc:docMk/>
            <pc:sldMk cId="1325698237" sldId="267"/>
            <ac:picMk id="49" creationId="{8EECEE46-7C2F-EE4A-AAE6-FF696D5E56C5}"/>
          </ac:picMkLst>
        </pc:picChg>
        <pc:picChg chg="add mod">
          <ac:chgData name="MAURIZIO AURORA" userId="2e4518e9-735f-400a-98c7-f8014a7e3fcf" providerId="ADAL" clId="{2117C0FC-09D9-AA44-AFDF-172D540D6279}" dt="2024-10-18T15:54:42.581" v="921" actId="167"/>
          <ac:picMkLst>
            <pc:docMk/>
            <pc:sldMk cId="1325698237" sldId="267"/>
            <ac:picMk id="55" creationId="{9BB0282B-5570-F840-BB6D-F266580E6056}"/>
          </ac:picMkLst>
        </pc:picChg>
        <pc:picChg chg="add del mod">
          <ac:chgData name="MAURIZIO AURORA" userId="2e4518e9-735f-400a-98c7-f8014a7e3fcf" providerId="ADAL" clId="{2117C0FC-09D9-AA44-AFDF-172D540D6279}" dt="2024-10-18T15:57:00.261" v="938" actId="478"/>
          <ac:picMkLst>
            <pc:docMk/>
            <pc:sldMk cId="1325698237" sldId="267"/>
            <ac:picMk id="58" creationId="{A7F982CE-A997-904B-B86A-CAE4CE0E0A97}"/>
          </ac:picMkLst>
        </pc:picChg>
        <pc:picChg chg="add mod">
          <ac:chgData name="MAURIZIO AURORA" userId="2e4518e9-735f-400a-98c7-f8014a7e3fcf" providerId="ADAL" clId="{2117C0FC-09D9-AA44-AFDF-172D540D6279}" dt="2024-10-18T15:58:59.729" v="1019" actId="1037"/>
          <ac:picMkLst>
            <pc:docMk/>
            <pc:sldMk cId="1325698237" sldId="267"/>
            <ac:picMk id="60" creationId="{3BBA9F5E-1CBF-CE42-816F-95C6ADB1B17F}"/>
          </ac:picMkLst>
        </pc:picChg>
      </pc:sldChg>
    </pc:docChg>
  </pc:docChgLst>
  <pc:docChgLst>
    <pc:chgData name="MAURIZIO AURORA" userId="S::maurizio.aurora@hsr.it::2e4518e9-735f-400a-98c7-f8014a7e3fcf" providerId="AD" clId="Web-{9D68DCDA-2B93-4B58-BDFB-3EA6DDACA25B}"/>
    <pc:docChg chg="modSld">
      <pc:chgData name="MAURIZIO AURORA" userId="S::maurizio.aurora@hsr.it::2e4518e9-735f-400a-98c7-f8014a7e3fcf" providerId="AD" clId="Web-{9D68DCDA-2B93-4B58-BDFB-3EA6DDACA25B}" dt="2024-10-23T14:28:10.738" v="24" actId="1076"/>
      <pc:docMkLst>
        <pc:docMk/>
      </pc:docMkLst>
      <pc:sldChg chg="addSp delSp modSp">
        <pc:chgData name="MAURIZIO AURORA" userId="S::maurizio.aurora@hsr.it::2e4518e9-735f-400a-98c7-f8014a7e3fcf" providerId="AD" clId="Web-{9D68DCDA-2B93-4B58-BDFB-3EA6DDACA25B}" dt="2024-10-23T14:28:10.738" v="24" actId="1076"/>
        <pc:sldMkLst>
          <pc:docMk/>
          <pc:sldMk cId="2835637795" sldId="269"/>
        </pc:sldMkLst>
        <pc:spChg chg="mod">
          <ac:chgData name="MAURIZIO AURORA" userId="S::maurizio.aurora@hsr.it::2e4518e9-735f-400a-98c7-f8014a7e3fcf" providerId="AD" clId="Web-{9D68DCDA-2B93-4B58-BDFB-3EA6DDACA25B}" dt="2024-10-23T14:28:06.332" v="23" actId="1076"/>
          <ac:spMkLst>
            <pc:docMk/>
            <pc:sldMk cId="2835637795" sldId="269"/>
            <ac:spMk id="53" creationId="{F96FF8B6-81C5-4546-B186-EF48C0D7FB55}"/>
          </ac:spMkLst>
        </pc:spChg>
        <pc:picChg chg="add del mod">
          <ac:chgData name="MAURIZIO AURORA" userId="S::maurizio.aurora@hsr.it::2e4518e9-735f-400a-98c7-f8014a7e3fcf" providerId="AD" clId="Web-{9D68DCDA-2B93-4B58-BDFB-3EA6DDACA25B}" dt="2024-10-23T14:25:32.466" v="2"/>
          <ac:picMkLst>
            <pc:docMk/>
            <pc:sldMk cId="2835637795" sldId="269"/>
            <ac:picMk id="3" creationId="{99BD92E5-08FD-C503-4F63-C8AE061FF79E}"/>
          </ac:picMkLst>
        </pc:picChg>
        <pc:picChg chg="add del mod">
          <ac:chgData name="MAURIZIO AURORA" userId="S::maurizio.aurora@hsr.it::2e4518e9-735f-400a-98c7-f8014a7e3fcf" providerId="AD" clId="Web-{9D68DCDA-2B93-4B58-BDFB-3EA6DDACA25B}" dt="2024-10-23T14:25:50.717" v="5"/>
          <ac:picMkLst>
            <pc:docMk/>
            <pc:sldMk cId="2835637795" sldId="269"/>
            <ac:picMk id="4" creationId="{F8080533-8930-3761-E864-043DE0802867}"/>
          </ac:picMkLst>
        </pc:picChg>
        <pc:picChg chg="add del mod">
          <ac:chgData name="MAURIZIO AURORA" userId="S::maurizio.aurora@hsr.it::2e4518e9-735f-400a-98c7-f8014a7e3fcf" providerId="AD" clId="Web-{9D68DCDA-2B93-4B58-BDFB-3EA6DDACA25B}" dt="2024-10-23T14:25:56.702" v="7"/>
          <ac:picMkLst>
            <pc:docMk/>
            <pc:sldMk cId="2835637795" sldId="269"/>
            <ac:picMk id="5" creationId="{8875607C-781F-1B93-49E5-CAF673DF176F}"/>
          </ac:picMkLst>
        </pc:picChg>
        <pc:picChg chg="add del mod ord">
          <ac:chgData name="MAURIZIO AURORA" userId="S::maurizio.aurora@hsr.it::2e4518e9-735f-400a-98c7-f8014a7e3fcf" providerId="AD" clId="Web-{9D68DCDA-2B93-4B58-BDFB-3EA6DDACA25B}" dt="2024-10-23T14:26:57.610" v="16"/>
          <ac:picMkLst>
            <pc:docMk/>
            <pc:sldMk cId="2835637795" sldId="269"/>
            <ac:picMk id="9" creationId="{6A985DAE-7B05-4F65-DAD3-06BCF4413DA6}"/>
          </ac:picMkLst>
        </pc:picChg>
        <pc:picChg chg="add mod">
          <ac:chgData name="MAURIZIO AURORA" userId="S::maurizio.aurora@hsr.it::2e4518e9-735f-400a-98c7-f8014a7e3fcf" providerId="AD" clId="Web-{9D68DCDA-2B93-4B58-BDFB-3EA6DDACA25B}" dt="2024-10-23T14:28:10.738" v="24" actId="1076"/>
          <ac:picMkLst>
            <pc:docMk/>
            <pc:sldMk cId="2835637795" sldId="269"/>
            <ac:picMk id="13" creationId="{138B80D6-C757-E9CE-4236-29677449AB18}"/>
          </ac:picMkLst>
        </pc:picChg>
        <pc:picChg chg="del">
          <ac:chgData name="MAURIZIO AURORA" userId="S::maurizio.aurora@hsr.it::2e4518e9-735f-400a-98c7-f8014a7e3fcf" providerId="AD" clId="Web-{9D68DCDA-2B93-4B58-BDFB-3EA6DDACA25B}" dt="2024-10-23T14:25:17.997" v="0"/>
          <ac:picMkLst>
            <pc:docMk/>
            <pc:sldMk cId="2835637795" sldId="269"/>
            <ac:picMk id="55" creationId="{9BB0282B-5570-F840-BB6D-F266580E605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CA6557-B5DA-B842-9609-30268D8574DA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25863" y="857250"/>
            <a:ext cx="1692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54E916-4A71-414E-8E44-388D80E4D0C1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55053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1pPr>
    <a:lvl2pPr marL="2314255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2pPr>
    <a:lvl3pPr marL="4628510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3pPr>
    <a:lvl4pPr marL="6942765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4pPr>
    <a:lvl5pPr marL="9257020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5pPr>
    <a:lvl6pPr marL="11571275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6pPr>
    <a:lvl7pPr marL="13885530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7pPr>
    <a:lvl8pPr marL="16199785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8pPr>
    <a:lvl9pPr marL="18514040" algn="l" defTabSz="4628510" rtl="0" eaLnBrk="1" latinLnBrk="0" hangingPunct="1">
      <a:defRPr sz="607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54E916-4A71-414E-8E44-388D80E4D0C1}" type="slidenum">
              <a:rPr lang="en-IT" smtClean="0"/>
              <a:t>1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6136298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T" i="0"/>
              <a:t>Barplots genereted with the SurfR function </a:t>
            </a:r>
            <a:r>
              <a:rPr lang="en-GB" sz="1800" i="1" err="1">
                <a:effectLst/>
                <a:latin typeface="Inconsolatazi4"/>
              </a:rPr>
              <a:t>Enrichment_barplot</a:t>
            </a:r>
            <a:r>
              <a:rPr lang="en-GB" sz="1800">
                <a:effectLst/>
                <a:latin typeface="Inconsolatazi4"/>
              </a:rPr>
              <a:t> </a:t>
            </a:r>
            <a:r>
              <a:rPr lang="en-IT" i="0"/>
              <a:t>representing the ten most significant pathways of the GO Celular Compartments database in the comparisons Surface Proteins vs non Surface Proteins. From top to bottom we show: A) the 10 most significant upregulated pathways in TCGA-CHOL, B) the 10 most significant downregulated pathways in TCGA-CHOL, C) the 10 most significant upregulated pathways in GSE107943, D) the 10 most significant downregulated pathways in GSE107943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54E916-4A71-414E-8E44-388D80E4D0C1}" type="slidenum">
              <a:rPr lang="en-IT" smtClean="0"/>
              <a:t>2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852648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err="1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Barplots</a:t>
            </a:r>
            <a:r>
              <a:rPr lang="en-US" sz="1800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 generated with the </a:t>
            </a:r>
            <a:r>
              <a:rPr lang="en-US" sz="1800" err="1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SurfR</a:t>
            </a:r>
            <a:r>
              <a:rPr lang="en-US" sz="1800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 function Enrichment </a:t>
            </a:r>
            <a:r>
              <a:rPr lang="en-US" sz="1800" err="1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barplot</a:t>
            </a:r>
            <a:r>
              <a:rPr lang="en-US" sz="1800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 representing the ten most significant up-regulated pathways of the GO Biological Pathways database, within a tumor/normal comparison </a:t>
            </a:r>
            <a:r>
              <a:rPr lang="en-US" sz="1800" err="1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subsetting</a:t>
            </a:r>
            <a:r>
              <a:rPr lang="en-US" sz="1800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Cambria" panose="02040503050406030204" pitchFamily="18" charset="0"/>
              </a:rPr>
              <a:t> non SPs, for two cholangiocarcinoma datasets (GSE107943 (left) and TCGA-CHOL (right));</a:t>
            </a:r>
            <a:r>
              <a:rPr lang="en-IT">
                <a:effectLst/>
              </a:rPr>
              <a:t> </a:t>
            </a:r>
            <a:endParaRPr lang="en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54E916-4A71-414E-8E44-388D80E4D0C1}" type="slidenum">
              <a:rPr lang="en-IT" smtClean="0"/>
              <a:t>3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5126328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T" i="0"/>
              <a:t>A. Barplots genereted with the SurfR function </a:t>
            </a:r>
            <a:r>
              <a:rPr lang="en-GB" sz="1800" i="1" err="1">
                <a:effectLst/>
                <a:latin typeface="Inconsolatazi4"/>
              </a:rPr>
              <a:t>Enrichment_barplot</a:t>
            </a:r>
            <a:r>
              <a:rPr lang="en-GB" sz="1800">
                <a:effectLst/>
                <a:latin typeface="Inconsolatazi4"/>
              </a:rPr>
              <a:t> </a:t>
            </a:r>
            <a:r>
              <a:rPr lang="en-IT" i="0"/>
              <a:t>representing the ten most significant upregulated pathways subsetting SP (top panels) and nSP (bottom panels) of the </a:t>
            </a:r>
            <a:r>
              <a:rPr lang="en-IT" b="1" i="0"/>
              <a:t>GO Cellular Component </a:t>
            </a:r>
            <a:r>
              <a:rPr lang="en-IT" i="0"/>
              <a:t>database in the comparisons tumor vs normal for the cholangiocarcinoma datasets (GSE107943 and TCGA-CHOL in the left and right panels, respectively); </a:t>
            </a:r>
          </a:p>
          <a:p>
            <a:pPr marL="0" marR="0" lvl="0" indent="0" algn="l" defTabSz="46285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T" i="0"/>
              <a:t>B. Barplots genereted with the SurfR function </a:t>
            </a:r>
            <a:r>
              <a:rPr lang="en-GB" sz="1800" i="1" err="1">
                <a:effectLst/>
                <a:latin typeface="Inconsolatazi4"/>
              </a:rPr>
              <a:t>Enrichment_barplot</a:t>
            </a:r>
            <a:r>
              <a:rPr lang="en-GB" sz="1800">
                <a:effectLst/>
                <a:latin typeface="Inconsolatazi4"/>
              </a:rPr>
              <a:t> </a:t>
            </a:r>
            <a:r>
              <a:rPr lang="en-IT" i="0"/>
              <a:t>representing the ten most significant upregulated pathways subsetting SP (top panels) and nSP (bottom panels) of the </a:t>
            </a:r>
            <a:r>
              <a:rPr lang="en-IT" b="1" i="0"/>
              <a:t>GO Molecular Function</a:t>
            </a:r>
            <a:r>
              <a:rPr lang="en-IT" i="0"/>
              <a:t> database in the comparisons tumor vs normal for the cholangiocarcinoma datasets (GSE107943 and TCGA-CHOL in the left and right panels, respectively); </a:t>
            </a:r>
          </a:p>
          <a:p>
            <a:endParaRPr lang="en-IT" i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54E916-4A71-414E-8E44-388D80E4D0C1}" type="slidenum">
              <a:rPr lang="en-IT" smtClean="0"/>
              <a:t>4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77064206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/>
              <a:t>M</a:t>
            </a:r>
            <a:r>
              <a:rPr lang="en-IT"/>
              <a:t>eta-analysis</a:t>
            </a:r>
          </a:p>
          <a:p>
            <a:r>
              <a:rPr lang="en-IT"/>
              <a:t>A) Histogram of pvalue distribution – </a:t>
            </a:r>
            <a:r>
              <a:rPr lang="en-IT" sz="6600"/>
              <a:t>fishercomb method;</a:t>
            </a:r>
            <a:endParaRPr lang="en-IT"/>
          </a:p>
          <a:p>
            <a:pPr marL="0" marR="0" lvl="0" indent="0" algn="l" defTabSz="46285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T"/>
              <a:t>B) Histogram of pvalue distribution – </a:t>
            </a:r>
            <a:r>
              <a:rPr lang="en-IT" sz="6600"/>
              <a:t>invnorm method;</a:t>
            </a:r>
          </a:p>
          <a:p>
            <a:pPr marL="0" marR="0" lvl="0" indent="0" algn="l" defTabSz="46285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T" sz="6600"/>
              <a:t>C) </a:t>
            </a:r>
            <a:r>
              <a:rPr lang="en-IT" sz="6600" i="0"/>
              <a:t>Venn diagram showing all the common upregulated surface proteins most expressed in the tumor choorts of GSE107943, TCGA-CHOL and their meta-analysis. The plot was produced with the SurfR funtion </a:t>
            </a:r>
            <a:r>
              <a:rPr lang="en-IT" sz="6600" i="1"/>
              <a:t>S</a:t>
            </a:r>
            <a:r>
              <a:rPr lang="en-GB" sz="6600" i="1"/>
              <a:t>v</a:t>
            </a:r>
            <a:r>
              <a:rPr lang="en-IT" sz="6600" i="1"/>
              <a:t>enn</a:t>
            </a:r>
            <a:r>
              <a:rPr lang="en-IT" sz="6600" i="0"/>
              <a:t>; </a:t>
            </a:r>
            <a:endParaRPr lang="en-IT" sz="6600"/>
          </a:p>
          <a:p>
            <a:pPr marL="0" marR="0" lvl="0" indent="0" algn="l" defTabSz="462851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T" sz="6600"/>
              <a:t>D) </a:t>
            </a:r>
            <a:r>
              <a:rPr lang="en-IT" sz="6600" i="0"/>
              <a:t>Venn diagram showing the common upregulated surface proteins, subsetted considering their expression in the tumor choorts of GSE107943, TCGA-CHOL and their meta-analysis. The plot was produced with the SurfR funtion </a:t>
            </a:r>
            <a:r>
              <a:rPr lang="en-IT" sz="6600" i="1"/>
              <a:t>S</a:t>
            </a:r>
            <a:r>
              <a:rPr lang="en-GB" sz="6600" i="1"/>
              <a:t>v</a:t>
            </a:r>
            <a:r>
              <a:rPr lang="en-IT" sz="6600" i="1"/>
              <a:t>enn</a:t>
            </a:r>
            <a:r>
              <a:rPr lang="en-IT" sz="6600" i="0"/>
              <a:t>; </a:t>
            </a:r>
            <a:endParaRPr lang="en-IT"/>
          </a:p>
          <a:p>
            <a:endParaRPr lang="en-IT"/>
          </a:p>
          <a:p>
            <a:endParaRPr lang="en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54E916-4A71-414E-8E44-388D80E4D0C1}" type="slidenum">
              <a:rPr lang="en-IT" smtClean="0"/>
              <a:t>5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419048002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IT"/>
              <a:t>SurfR beyond cancer: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54E916-4A71-414E-8E44-388D80E4D0C1}" type="slidenum">
              <a:rPr lang="en-IT" smtClean="0"/>
              <a:t>6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3218915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64964" y="7659088"/>
            <a:ext cx="29069586" cy="16293159"/>
          </a:xfrm>
        </p:spPr>
        <p:txBody>
          <a:bodyPr anchor="b"/>
          <a:lstStyle>
            <a:lvl1pPr algn="ctr">
              <a:defRPr sz="2244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274939" y="24580574"/>
            <a:ext cx="25649635" cy="11299043"/>
          </a:xfrm>
        </p:spPr>
        <p:txBody>
          <a:bodyPr/>
          <a:lstStyle>
            <a:lvl1pPr marL="0" indent="0" algn="ctr">
              <a:buNone/>
              <a:defRPr sz="8976"/>
            </a:lvl1pPr>
            <a:lvl2pPr marL="1709974" indent="0" algn="ctr">
              <a:buNone/>
              <a:defRPr sz="7480"/>
            </a:lvl2pPr>
            <a:lvl3pPr marL="3419947" indent="0" algn="ctr">
              <a:buNone/>
              <a:defRPr sz="6732"/>
            </a:lvl3pPr>
            <a:lvl4pPr marL="5129921" indent="0" algn="ctr">
              <a:buNone/>
              <a:defRPr sz="5984"/>
            </a:lvl4pPr>
            <a:lvl5pPr marL="6839895" indent="0" algn="ctr">
              <a:buNone/>
              <a:defRPr sz="5984"/>
            </a:lvl5pPr>
            <a:lvl6pPr marL="8549869" indent="0" algn="ctr">
              <a:buNone/>
              <a:defRPr sz="5984"/>
            </a:lvl6pPr>
            <a:lvl7pPr marL="10259842" indent="0" algn="ctr">
              <a:buNone/>
              <a:defRPr sz="5984"/>
            </a:lvl7pPr>
            <a:lvl8pPr marL="11969816" indent="0" algn="ctr">
              <a:buNone/>
              <a:defRPr sz="5984"/>
            </a:lvl8pPr>
            <a:lvl9pPr marL="13679790" indent="0" algn="ctr">
              <a:buNone/>
              <a:defRPr sz="5984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938805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085784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4474028" y="2491640"/>
            <a:ext cx="7374270" cy="3966041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351218" y="2491640"/>
            <a:ext cx="21695316" cy="3966041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133297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02344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33406" y="11667389"/>
            <a:ext cx="29497080" cy="19467289"/>
          </a:xfrm>
        </p:spPr>
        <p:txBody>
          <a:bodyPr anchor="b"/>
          <a:lstStyle>
            <a:lvl1pPr>
              <a:defRPr sz="2244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33406" y="31318846"/>
            <a:ext cx="29497080" cy="10237387"/>
          </a:xfrm>
        </p:spPr>
        <p:txBody>
          <a:bodyPr/>
          <a:lstStyle>
            <a:lvl1pPr marL="0" indent="0">
              <a:buNone/>
              <a:defRPr sz="8976">
                <a:solidFill>
                  <a:schemeClr val="tx1">
                    <a:tint val="82000"/>
                  </a:schemeClr>
                </a:solidFill>
              </a:defRPr>
            </a:lvl1pPr>
            <a:lvl2pPr marL="1709974" indent="0">
              <a:buNone/>
              <a:defRPr sz="7480">
                <a:solidFill>
                  <a:schemeClr val="tx1">
                    <a:tint val="82000"/>
                  </a:schemeClr>
                </a:solidFill>
              </a:defRPr>
            </a:lvl2pPr>
            <a:lvl3pPr marL="3419947" indent="0">
              <a:buNone/>
              <a:defRPr sz="6732">
                <a:solidFill>
                  <a:schemeClr val="tx1">
                    <a:tint val="82000"/>
                  </a:schemeClr>
                </a:solidFill>
              </a:defRPr>
            </a:lvl3pPr>
            <a:lvl4pPr marL="5129921" indent="0">
              <a:buNone/>
              <a:defRPr sz="5984">
                <a:solidFill>
                  <a:schemeClr val="tx1">
                    <a:tint val="82000"/>
                  </a:schemeClr>
                </a:solidFill>
              </a:defRPr>
            </a:lvl4pPr>
            <a:lvl5pPr marL="6839895" indent="0">
              <a:buNone/>
              <a:defRPr sz="5984">
                <a:solidFill>
                  <a:schemeClr val="tx1">
                    <a:tint val="82000"/>
                  </a:schemeClr>
                </a:solidFill>
              </a:defRPr>
            </a:lvl5pPr>
            <a:lvl6pPr marL="8549869" indent="0">
              <a:buNone/>
              <a:defRPr sz="5984">
                <a:solidFill>
                  <a:schemeClr val="tx1">
                    <a:tint val="82000"/>
                  </a:schemeClr>
                </a:solidFill>
              </a:defRPr>
            </a:lvl6pPr>
            <a:lvl7pPr marL="10259842" indent="0">
              <a:buNone/>
              <a:defRPr sz="5984">
                <a:solidFill>
                  <a:schemeClr val="tx1">
                    <a:tint val="82000"/>
                  </a:schemeClr>
                </a:solidFill>
              </a:defRPr>
            </a:lvl7pPr>
            <a:lvl8pPr marL="11969816" indent="0">
              <a:buNone/>
              <a:defRPr sz="5984">
                <a:solidFill>
                  <a:schemeClr val="tx1">
                    <a:tint val="82000"/>
                  </a:schemeClr>
                </a:solidFill>
              </a:defRPr>
            </a:lvl8pPr>
            <a:lvl9pPr marL="13679790" indent="0">
              <a:buNone/>
              <a:defRPr sz="598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20389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351217" y="12458200"/>
            <a:ext cx="14534793" cy="2969385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13503" y="12458200"/>
            <a:ext cx="14534793" cy="2969385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987020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671" y="2491650"/>
            <a:ext cx="29497080" cy="904574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55675" y="11472381"/>
            <a:ext cx="14467995" cy="5622437"/>
          </a:xfrm>
        </p:spPr>
        <p:txBody>
          <a:bodyPr anchor="b"/>
          <a:lstStyle>
            <a:lvl1pPr marL="0" indent="0">
              <a:buNone/>
              <a:defRPr sz="8976" b="1"/>
            </a:lvl1pPr>
            <a:lvl2pPr marL="1709974" indent="0">
              <a:buNone/>
              <a:defRPr sz="7480" b="1"/>
            </a:lvl2pPr>
            <a:lvl3pPr marL="3419947" indent="0">
              <a:buNone/>
              <a:defRPr sz="6732" b="1"/>
            </a:lvl3pPr>
            <a:lvl4pPr marL="5129921" indent="0">
              <a:buNone/>
              <a:defRPr sz="5984" b="1"/>
            </a:lvl4pPr>
            <a:lvl5pPr marL="6839895" indent="0">
              <a:buNone/>
              <a:defRPr sz="5984" b="1"/>
            </a:lvl5pPr>
            <a:lvl6pPr marL="8549869" indent="0">
              <a:buNone/>
              <a:defRPr sz="5984" b="1"/>
            </a:lvl6pPr>
            <a:lvl7pPr marL="10259842" indent="0">
              <a:buNone/>
              <a:defRPr sz="5984" b="1"/>
            </a:lvl7pPr>
            <a:lvl8pPr marL="11969816" indent="0">
              <a:buNone/>
              <a:defRPr sz="5984" b="1"/>
            </a:lvl8pPr>
            <a:lvl9pPr marL="13679790" indent="0">
              <a:buNone/>
              <a:defRPr sz="598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55675" y="17094818"/>
            <a:ext cx="14467995" cy="2514390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7313506" y="11472381"/>
            <a:ext cx="14539247" cy="5622437"/>
          </a:xfrm>
        </p:spPr>
        <p:txBody>
          <a:bodyPr anchor="b"/>
          <a:lstStyle>
            <a:lvl1pPr marL="0" indent="0">
              <a:buNone/>
              <a:defRPr sz="8976" b="1"/>
            </a:lvl1pPr>
            <a:lvl2pPr marL="1709974" indent="0">
              <a:buNone/>
              <a:defRPr sz="7480" b="1"/>
            </a:lvl2pPr>
            <a:lvl3pPr marL="3419947" indent="0">
              <a:buNone/>
              <a:defRPr sz="6732" b="1"/>
            </a:lvl3pPr>
            <a:lvl4pPr marL="5129921" indent="0">
              <a:buNone/>
              <a:defRPr sz="5984" b="1"/>
            </a:lvl4pPr>
            <a:lvl5pPr marL="6839895" indent="0">
              <a:buNone/>
              <a:defRPr sz="5984" b="1"/>
            </a:lvl5pPr>
            <a:lvl6pPr marL="8549869" indent="0">
              <a:buNone/>
              <a:defRPr sz="5984" b="1"/>
            </a:lvl6pPr>
            <a:lvl7pPr marL="10259842" indent="0">
              <a:buNone/>
              <a:defRPr sz="5984" b="1"/>
            </a:lvl7pPr>
            <a:lvl8pPr marL="11969816" indent="0">
              <a:buNone/>
              <a:defRPr sz="5984" b="1"/>
            </a:lvl8pPr>
            <a:lvl9pPr marL="13679790" indent="0">
              <a:buNone/>
              <a:defRPr sz="598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7313506" y="17094818"/>
            <a:ext cx="14539247" cy="2514390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82967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00106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698882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671" y="3119967"/>
            <a:ext cx="11030233" cy="10919883"/>
          </a:xfrm>
        </p:spPr>
        <p:txBody>
          <a:bodyPr anchor="b"/>
          <a:lstStyle>
            <a:lvl1pPr>
              <a:defRPr sz="11968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539248" y="6738272"/>
            <a:ext cx="17313503" cy="33257978"/>
          </a:xfrm>
        </p:spPr>
        <p:txBody>
          <a:bodyPr/>
          <a:lstStyle>
            <a:lvl1pPr>
              <a:defRPr sz="11968"/>
            </a:lvl1pPr>
            <a:lvl2pPr>
              <a:defRPr sz="10472"/>
            </a:lvl2pPr>
            <a:lvl3pPr>
              <a:defRPr sz="8976"/>
            </a:lvl3pPr>
            <a:lvl4pPr>
              <a:defRPr sz="7480"/>
            </a:lvl4pPr>
            <a:lvl5pPr>
              <a:defRPr sz="7480"/>
            </a:lvl5pPr>
            <a:lvl6pPr>
              <a:defRPr sz="7480"/>
            </a:lvl6pPr>
            <a:lvl7pPr>
              <a:defRPr sz="7480"/>
            </a:lvl7pPr>
            <a:lvl8pPr>
              <a:defRPr sz="7480"/>
            </a:lvl8pPr>
            <a:lvl9pPr>
              <a:defRPr sz="748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55671" y="14039850"/>
            <a:ext cx="11030233" cy="26010559"/>
          </a:xfrm>
        </p:spPr>
        <p:txBody>
          <a:bodyPr/>
          <a:lstStyle>
            <a:lvl1pPr marL="0" indent="0">
              <a:buNone/>
              <a:defRPr sz="5984"/>
            </a:lvl1pPr>
            <a:lvl2pPr marL="1709974" indent="0">
              <a:buNone/>
              <a:defRPr sz="5236"/>
            </a:lvl2pPr>
            <a:lvl3pPr marL="3419947" indent="0">
              <a:buNone/>
              <a:defRPr sz="4488"/>
            </a:lvl3pPr>
            <a:lvl4pPr marL="5129921" indent="0">
              <a:buNone/>
              <a:defRPr sz="3740"/>
            </a:lvl4pPr>
            <a:lvl5pPr marL="6839895" indent="0">
              <a:buNone/>
              <a:defRPr sz="3740"/>
            </a:lvl5pPr>
            <a:lvl6pPr marL="8549869" indent="0">
              <a:buNone/>
              <a:defRPr sz="3740"/>
            </a:lvl6pPr>
            <a:lvl7pPr marL="10259842" indent="0">
              <a:buNone/>
              <a:defRPr sz="3740"/>
            </a:lvl7pPr>
            <a:lvl8pPr marL="11969816" indent="0">
              <a:buNone/>
              <a:defRPr sz="3740"/>
            </a:lvl8pPr>
            <a:lvl9pPr marL="13679790" indent="0">
              <a:buNone/>
              <a:defRPr sz="374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937963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5671" y="3119967"/>
            <a:ext cx="11030233" cy="10919883"/>
          </a:xfrm>
        </p:spPr>
        <p:txBody>
          <a:bodyPr anchor="b"/>
          <a:lstStyle>
            <a:lvl1pPr>
              <a:defRPr sz="11968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4539248" y="6738272"/>
            <a:ext cx="17313503" cy="33257978"/>
          </a:xfrm>
        </p:spPr>
        <p:txBody>
          <a:bodyPr anchor="t"/>
          <a:lstStyle>
            <a:lvl1pPr marL="0" indent="0">
              <a:buNone/>
              <a:defRPr sz="11968"/>
            </a:lvl1pPr>
            <a:lvl2pPr marL="1709974" indent="0">
              <a:buNone/>
              <a:defRPr sz="10472"/>
            </a:lvl2pPr>
            <a:lvl3pPr marL="3419947" indent="0">
              <a:buNone/>
              <a:defRPr sz="8976"/>
            </a:lvl3pPr>
            <a:lvl4pPr marL="5129921" indent="0">
              <a:buNone/>
              <a:defRPr sz="7480"/>
            </a:lvl4pPr>
            <a:lvl5pPr marL="6839895" indent="0">
              <a:buNone/>
              <a:defRPr sz="7480"/>
            </a:lvl5pPr>
            <a:lvl6pPr marL="8549869" indent="0">
              <a:buNone/>
              <a:defRPr sz="7480"/>
            </a:lvl6pPr>
            <a:lvl7pPr marL="10259842" indent="0">
              <a:buNone/>
              <a:defRPr sz="7480"/>
            </a:lvl7pPr>
            <a:lvl8pPr marL="11969816" indent="0">
              <a:buNone/>
              <a:defRPr sz="7480"/>
            </a:lvl8pPr>
            <a:lvl9pPr marL="13679790" indent="0">
              <a:buNone/>
              <a:defRPr sz="748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55671" y="14039850"/>
            <a:ext cx="11030233" cy="26010559"/>
          </a:xfrm>
        </p:spPr>
        <p:txBody>
          <a:bodyPr/>
          <a:lstStyle>
            <a:lvl1pPr marL="0" indent="0">
              <a:buNone/>
              <a:defRPr sz="5984"/>
            </a:lvl1pPr>
            <a:lvl2pPr marL="1709974" indent="0">
              <a:buNone/>
              <a:defRPr sz="5236"/>
            </a:lvl2pPr>
            <a:lvl3pPr marL="3419947" indent="0">
              <a:buNone/>
              <a:defRPr sz="4488"/>
            </a:lvl3pPr>
            <a:lvl4pPr marL="5129921" indent="0">
              <a:buNone/>
              <a:defRPr sz="3740"/>
            </a:lvl4pPr>
            <a:lvl5pPr marL="6839895" indent="0">
              <a:buNone/>
              <a:defRPr sz="3740"/>
            </a:lvl5pPr>
            <a:lvl6pPr marL="8549869" indent="0">
              <a:buNone/>
              <a:defRPr sz="3740"/>
            </a:lvl6pPr>
            <a:lvl7pPr marL="10259842" indent="0">
              <a:buNone/>
              <a:defRPr sz="3740"/>
            </a:lvl7pPr>
            <a:lvl8pPr marL="11969816" indent="0">
              <a:buNone/>
              <a:defRPr sz="3740"/>
            </a:lvl8pPr>
            <a:lvl9pPr marL="13679790" indent="0">
              <a:buNone/>
              <a:defRPr sz="374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786931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351217" y="2491650"/>
            <a:ext cx="29497080" cy="904574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351217" y="12458200"/>
            <a:ext cx="29497080" cy="296938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351217" y="43376214"/>
            <a:ext cx="7694890" cy="24916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48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D6AA63-F42B-2A47-ACAB-F2637162F92B}" type="datetimeFigureOut">
              <a:rPr lang="en-IT" smtClean="0"/>
              <a:t>10/23/2024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328589" y="43376214"/>
            <a:ext cx="11542336" cy="24916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48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4153406" y="43376214"/>
            <a:ext cx="7694890" cy="24916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48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32E78E5-60AB-F647-8594-E982A826FE43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540217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419947" rtl="0" eaLnBrk="1" latinLnBrk="0" hangingPunct="1">
        <a:lnSpc>
          <a:spcPct val="90000"/>
        </a:lnSpc>
        <a:spcBef>
          <a:spcPct val="0"/>
        </a:spcBef>
        <a:buNone/>
        <a:defRPr sz="164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54987" indent="-854987" algn="l" defTabSz="3419947" rtl="0" eaLnBrk="1" latinLnBrk="0" hangingPunct="1">
        <a:lnSpc>
          <a:spcPct val="90000"/>
        </a:lnSpc>
        <a:spcBef>
          <a:spcPts val="3740"/>
        </a:spcBef>
        <a:buFont typeface="Arial" panose="020B0604020202020204" pitchFamily="34" charset="0"/>
        <a:buChar char="•"/>
        <a:defRPr sz="10472" kern="1200">
          <a:solidFill>
            <a:schemeClr val="tx1"/>
          </a:solidFill>
          <a:latin typeface="+mn-lt"/>
          <a:ea typeface="+mn-ea"/>
          <a:cs typeface="+mn-cs"/>
        </a:defRPr>
      </a:lvl1pPr>
      <a:lvl2pPr marL="2564961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8976" kern="1200">
          <a:solidFill>
            <a:schemeClr val="tx1"/>
          </a:solidFill>
          <a:latin typeface="+mn-lt"/>
          <a:ea typeface="+mn-ea"/>
          <a:cs typeface="+mn-cs"/>
        </a:defRPr>
      </a:lvl2pPr>
      <a:lvl3pPr marL="4274934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7480" kern="1200">
          <a:solidFill>
            <a:schemeClr val="tx1"/>
          </a:solidFill>
          <a:latin typeface="+mn-lt"/>
          <a:ea typeface="+mn-ea"/>
          <a:cs typeface="+mn-cs"/>
        </a:defRPr>
      </a:lvl3pPr>
      <a:lvl4pPr marL="5984908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6732" kern="1200">
          <a:solidFill>
            <a:schemeClr val="tx1"/>
          </a:solidFill>
          <a:latin typeface="+mn-lt"/>
          <a:ea typeface="+mn-ea"/>
          <a:cs typeface="+mn-cs"/>
        </a:defRPr>
      </a:lvl4pPr>
      <a:lvl5pPr marL="7694882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6732" kern="1200">
          <a:solidFill>
            <a:schemeClr val="tx1"/>
          </a:solidFill>
          <a:latin typeface="+mn-lt"/>
          <a:ea typeface="+mn-ea"/>
          <a:cs typeface="+mn-cs"/>
        </a:defRPr>
      </a:lvl5pPr>
      <a:lvl6pPr marL="9404855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6732" kern="1200">
          <a:solidFill>
            <a:schemeClr val="tx1"/>
          </a:solidFill>
          <a:latin typeface="+mn-lt"/>
          <a:ea typeface="+mn-ea"/>
          <a:cs typeface="+mn-cs"/>
        </a:defRPr>
      </a:lvl6pPr>
      <a:lvl7pPr marL="11114829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6732" kern="1200">
          <a:solidFill>
            <a:schemeClr val="tx1"/>
          </a:solidFill>
          <a:latin typeface="+mn-lt"/>
          <a:ea typeface="+mn-ea"/>
          <a:cs typeface="+mn-cs"/>
        </a:defRPr>
      </a:lvl7pPr>
      <a:lvl8pPr marL="12824803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6732" kern="1200">
          <a:solidFill>
            <a:schemeClr val="tx1"/>
          </a:solidFill>
          <a:latin typeface="+mn-lt"/>
          <a:ea typeface="+mn-ea"/>
          <a:cs typeface="+mn-cs"/>
        </a:defRPr>
      </a:lvl8pPr>
      <a:lvl9pPr marL="14534777" indent="-854987" algn="l" defTabSz="3419947" rtl="0" eaLnBrk="1" latinLnBrk="0" hangingPunct="1">
        <a:lnSpc>
          <a:spcPct val="90000"/>
        </a:lnSpc>
        <a:spcBef>
          <a:spcPts val="1870"/>
        </a:spcBef>
        <a:buFont typeface="Arial" panose="020B0604020202020204" pitchFamily="34" charset="0"/>
        <a:buChar char="•"/>
        <a:defRPr sz="673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1pPr>
      <a:lvl2pPr marL="1709974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2pPr>
      <a:lvl3pPr marL="3419947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3pPr>
      <a:lvl4pPr marL="5129921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4pPr>
      <a:lvl5pPr marL="6839895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5pPr>
      <a:lvl6pPr marL="8549869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6pPr>
      <a:lvl7pPr marL="10259842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7pPr>
      <a:lvl8pPr marL="11969816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8pPr>
      <a:lvl9pPr marL="13679790" algn="l" defTabSz="3419947" rtl="0" eaLnBrk="1" latinLnBrk="0" hangingPunct="1">
        <a:defRPr sz="673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tiff"/><Relationship Id="rId3" Type="http://schemas.openxmlformats.org/officeDocument/2006/relationships/image" Target="../media/image13.emf"/><Relationship Id="rId7" Type="http://schemas.openxmlformats.org/officeDocument/2006/relationships/image" Target="../media/image17.tiff"/><Relationship Id="rId12" Type="http://schemas.openxmlformats.org/officeDocument/2006/relationships/image" Target="../media/image22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11" Type="http://schemas.openxmlformats.org/officeDocument/2006/relationships/image" Target="../media/image21.tiff"/><Relationship Id="rId5" Type="http://schemas.openxmlformats.org/officeDocument/2006/relationships/image" Target="../media/image15.emf"/><Relationship Id="rId10" Type="http://schemas.openxmlformats.org/officeDocument/2006/relationships/image" Target="../media/image20.tiff"/><Relationship Id="rId4" Type="http://schemas.openxmlformats.org/officeDocument/2006/relationships/image" Target="../media/image14.emf"/><Relationship Id="rId9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FA7EC64-C1E8-5A4D-5A4B-BD77CE07DDFD}"/>
              </a:ext>
            </a:extLst>
          </p:cNvPr>
          <p:cNvSpPr txBox="1"/>
          <p:nvPr/>
        </p:nvSpPr>
        <p:spPr>
          <a:xfrm>
            <a:off x="29766312" y="91376"/>
            <a:ext cx="443320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0" b="1"/>
              <a:t>Figure S1</a:t>
            </a:r>
            <a:endParaRPr lang="en-IT" sz="8000" b="1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6EDE7E3-7541-AC51-A2F3-6D9CC82D93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328385"/>
            <a:ext cx="18942844" cy="18942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25683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F5AF13-EDA7-086C-4CCB-7247B1DE2E0D}"/>
              </a:ext>
            </a:extLst>
          </p:cNvPr>
          <p:cNvSpPr txBox="1"/>
          <p:nvPr/>
        </p:nvSpPr>
        <p:spPr>
          <a:xfrm>
            <a:off x="29664712" y="91376"/>
            <a:ext cx="443320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0" b="1"/>
              <a:t>Figure S2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AC822C9-B85D-72B4-2E90-9524852B81E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1970757" y="2020244"/>
            <a:ext cx="23399997" cy="935999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9BA4904-8C3F-9942-8AAB-CF59AB117A93}"/>
              </a:ext>
            </a:extLst>
          </p:cNvPr>
          <p:cNvSpPr txBox="1"/>
          <p:nvPr/>
        </p:nvSpPr>
        <p:spPr>
          <a:xfrm>
            <a:off x="968339" y="627510"/>
            <a:ext cx="1765861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A</a:t>
            </a:r>
            <a:r>
              <a:rPr lang="en-IT" sz="6000"/>
              <a:t> </a:t>
            </a:r>
            <a:r>
              <a:rPr lang="en-GB" sz="6000" i="1" err="1">
                <a:effectLst/>
                <a:latin typeface="Inconsolatazi4"/>
              </a:rPr>
              <a:t>Enrichment_barplot</a:t>
            </a:r>
            <a:r>
              <a:rPr lang="en-GB" sz="6000">
                <a:effectLst/>
                <a:latin typeface="Inconsolatazi4"/>
              </a:rPr>
              <a:t> of </a:t>
            </a:r>
            <a:r>
              <a:rPr lang="en-GB" sz="6000" err="1">
                <a:effectLst/>
                <a:latin typeface="Inconsolatazi4"/>
              </a:rPr>
              <a:t>t</a:t>
            </a:r>
            <a:r>
              <a:rPr lang="en-GB" sz="6000" err="1"/>
              <a:t>umor</a:t>
            </a:r>
            <a:r>
              <a:rPr lang="en-GB" sz="6000"/>
              <a:t> vs normal UP TCGA BP</a:t>
            </a:r>
            <a:endParaRPr lang="en-IT" sz="600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418A174-E9A4-CB5E-81B3-8F5630BECDE2}"/>
              </a:ext>
            </a:extLst>
          </p:cNvPr>
          <p:cNvSpPr txBox="1"/>
          <p:nvPr/>
        </p:nvSpPr>
        <p:spPr>
          <a:xfrm>
            <a:off x="1195558" y="11974193"/>
            <a:ext cx="1898571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B</a:t>
            </a:r>
            <a:r>
              <a:rPr lang="en-IT" sz="6000"/>
              <a:t> </a:t>
            </a:r>
            <a:r>
              <a:rPr lang="en-GB" sz="6000" i="1" err="1">
                <a:effectLst/>
                <a:latin typeface="Inconsolatazi4"/>
              </a:rPr>
              <a:t>Enrichment_barplot</a:t>
            </a:r>
            <a:r>
              <a:rPr lang="en-GB" sz="6000">
                <a:effectLst/>
                <a:latin typeface="Inconsolatazi4"/>
              </a:rPr>
              <a:t> of</a:t>
            </a:r>
            <a:r>
              <a:rPr lang="en-GB" sz="6000"/>
              <a:t> </a:t>
            </a:r>
            <a:r>
              <a:rPr lang="en-GB" sz="6000" err="1"/>
              <a:t>tumor</a:t>
            </a:r>
            <a:r>
              <a:rPr lang="en-GB" sz="6000"/>
              <a:t> vs normal DOWN TCGA BP</a:t>
            </a:r>
            <a:endParaRPr lang="en-IT" sz="600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D7160BD7-696D-3A85-441F-C3F2B1C2B53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1970757" y="36811991"/>
            <a:ext cx="23399997" cy="935999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39174B0-CACA-6729-835B-AE6DF7433DF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2172235" y="25184262"/>
            <a:ext cx="23399997" cy="935999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DFBA74B-4D73-DDB6-41D6-9049A7D725B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1970758" y="13556533"/>
            <a:ext cx="23399997" cy="935999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716ED3D-D78C-7210-D727-48CB3FACD584}"/>
              </a:ext>
            </a:extLst>
          </p:cNvPr>
          <p:cNvSpPr txBox="1"/>
          <p:nvPr/>
        </p:nvSpPr>
        <p:spPr>
          <a:xfrm>
            <a:off x="968339" y="23856948"/>
            <a:ext cx="1739104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C</a:t>
            </a:r>
            <a:r>
              <a:rPr lang="en-IT" sz="6000"/>
              <a:t> </a:t>
            </a:r>
            <a:r>
              <a:rPr lang="en-GB" sz="6000" i="1" err="1">
                <a:effectLst/>
                <a:latin typeface="Inconsolatazi4"/>
              </a:rPr>
              <a:t>Enrichment_barplot</a:t>
            </a:r>
            <a:r>
              <a:rPr lang="en-GB" sz="6000">
                <a:effectLst/>
                <a:latin typeface="Inconsolatazi4"/>
              </a:rPr>
              <a:t> of </a:t>
            </a:r>
            <a:r>
              <a:rPr lang="en-GB" sz="6000" err="1">
                <a:effectLst/>
                <a:latin typeface="Inconsolatazi4"/>
              </a:rPr>
              <a:t>t</a:t>
            </a:r>
            <a:r>
              <a:rPr lang="en-GB" sz="6000" err="1"/>
              <a:t>umor</a:t>
            </a:r>
            <a:r>
              <a:rPr lang="en-GB" sz="6000"/>
              <a:t> vs normal UP GEO BP</a:t>
            </a:r>
            <a:endParaRPr lang="en-IT" sz="600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39A8AC-53DA-81AE-3CF0-91F050C60C9B}"/>
              </a:ext>
            </a:extLst>
          </p:cNvPr>
          <p:cNvSpPr txBox="1"/>
          <p:nvPr/>
        </p:nvSpPr>
        <p:spPr>
          <a:xfrm>
            <a:off x="968339" y="35262397"/>
            <a:ext cx="1874699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D</a:t>
            </a:r>
            <a:r>
              <a:rPr lang="en-IT" sz="6000"/>
              <a:t> </a:t>
            </a:r>
            <a:r>
              <a:rPr lang="en-GB" sz="6000" i="1" err="1">
                <a:effectLst/>
                <a:latin typeface="Inconsolatazi4"/>
              </a:rPr>
              <a:t>Enrichment_barplot</a:t>
            </a:r>
            <a:r>
              <a:rPr lang="en-GB" sz="6000">
                <a:effectLst/>
                <a:latin typeface="Inconsolatazi4"/>
              </a:rPr>
              <a:t> of </a:t>
            </a:r>
            <a:r>
              <a:rPr lang="en-GB" sz="6000" err="1">
                <a:effectLst/>
                <a:latin typeface="Inconsolatazi4"/>
              </a:rPr>
              <a:t>t</a:t>
            </a:r>
            <a:r>
              <a:rPr lang="en-GB" sz="6000" err="1"/>
              <a:t>umor</a:t>
            </a:r>
            <a:r>
              <a:rPr lang="en-GB" sz="6000"/>
              <a:t> vs normal DOWN GEO BP</a:t>
            </a:r>
            <a:endParaRPr lang="en-IT" sz="6000"/>
          </a:p>
        </p:txBody>
      </p:sp>
    </p:spTree>
    <p:extLst>
      <p:ext uri="{BB962C8B-B14F-4D97-AF65-F5344CB8AC3E}">
        <p14:creationId xmlns:p14="http://schemas.microsoft.com/office/powerpoint/2010/main" val="8676442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09E897B-D346-DF02-C464-31508B7293C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036"/>
          <a:stretch/>
        </p:blipFill>
        <p:spPr>
          <a:xfrm>
            <a:off x="2266931" y="15959415"/>
            <a:ext cx="29665649" cy="1177899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59E2CBD-D519-0443-287A-8F06BA4895B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7361"/>
          <a:stretch/>
        </p:blipFill>
        <p:spPr>
          <a:xfrm>
            <a:off x="2266931" y="3332453"/>
            <a:ext cx="29665649" cy="1164469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9F978FA-F74E-01AB-2B3E-9EE2C0991337}"/>
              </a:ext>
            </a:extLst>
          </p:cNvPr>
          <p:cNvSpPr txBox="1"/>
          <p:nvPr/>
        </p:nvSpPr>
        <p:spPr>
          <a:xfrm>
            <a:off x="29664712" y="91376"/>
            <a:ext cx="443320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0" b="1"/>
              <a:t>Figure S3</a:t>
            </a:r>
            <a:endParaRPr lang="en-IT" sz="8000" b="1"/>
          </a:p>
        </p:txBody>
      </p:sp>
    </p:spTree>
    <p:extLst>
      <p:ext uri="{BB962C8B-B14F-4D97-AF65-F5344CB8AC3E}">
        <p14:creationId xmlns:p14="http://schemas.microsoft.com/office/powerpoint/2010/main" val="105346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F06DEF0-36AF-94D9-FB54-7A51E1354763}"/>
              </a:ext>
            </a:extLst>
          </p:cNvPr>
          <p:cNvSpPr txBox="1"/>
          <p:nvPr/>
        </p:nvSpPr>
        <p:spPr>
          <a:xfrm>
            <a:off x="968339" y="627510"/>
            <a:ext cx="13596927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A</a:t>
            </a:r>
            <a:r>
              <a:rPr lang="en-IT" sz="6000"/>
              <a:t> </a:t>
            </a:r>
            <a:r>
              <a:rPr lang="en-GB" sz="6000" i="1" err="1">
                <a:effectLst/>
                <a:latin typeface="Inconsolatazi4"/>
              </a:rPr>
              <a:t>Enrichment_barplot</a:t>
            </a:r>
            <a:r>
              <a:rPr lang="en-GB" sz="6000">
                <a:effectLst/>
                <a:latin typeface="Inconsolatazi4"/>
              </a:rPr>
              <a:t> </a:t>
            </a:r>
            <a:r>
              <a:rPr lang="en-GB" sz="6000" err="1">
                <a:effectLst/>
                <a:latin typeface="Inconsolatazi4"/>
              </a:rPr>
              <a:t>of</a:t>
            </a:r>
            <a:r>
              <a:rPr lang="en-GB" sz="6000" err="1"/>
              <a:t>_SP</a:t>
            </a:r>
            <a:r>
              <a:rPr lang="en-GB" sz="6000"/>
              <a:t> and </a:t>
            </a:r>
            <a:r>
              <a:rPr lang="en-GB" sz="6000" err="1"/>
              <a:t>nSP</a:t>
            </a:r>
            <a:r>
              <a:rPr lang="en-GB" sz="6000"/>
              <a:t> - CC</a:t>
            </a:r>
            <a:endParaRPr lang="en-IT" sz="60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5596EF-98E1-42B1-F62D-8768203C1B11}"/>
              </a:ext>
            </a:extLst>
          </p:cNvPr>
          <p:cNvSpPr txBox="1"/>
          <p:nvPr/>
        </p:nvSpPr>
        <p:spPr>
          <a:xfrm>
            <a:off x="968339" y="17108555"/>
            <a:ext cx="1370330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B</a:t>
            </a:r>
            <a:r>
              <a:rPr lang="en-IT" sz="6000"/>
              <a:t> </a:t>
            </a:r>
            <a:r>
              <a:rPr lang="en-GB" sz="6000" i="1" err="1">
                <a:effectLst/>
                <a:latin typeface="Inconsolatazi4"/>
              </a:rPr>
              <a:t>Enrichment_barplot</a:t>
            </a:r>
            <a:r>
              <a:rPr lang="en-GB" sz="6000">
                <a:effectLst/>
                <a:latin typeface="Inconsolatazi4"/>
              </a:rPr>
              <a:t> </a:t>
            </a:r>
            <a:r>
              <a:rPr lang="en-GB" sz="6000" err="1">
                <a:effectLst/>
                <a:latin typeface="Inconsolatazi4"/>
              </a:rPr>
              <a:t>of</a:t>
            </a:r>
            <a:r>
              <a:rPr lang="en-GB" sz="6000" err="1"/>
              <a:t>_SP</a:t>
            </a:r>
            <a:r>
              <a:rPr lang="en-GB" sz="6000"/>
              <a:t> and </a:t>
            </a:r>
            <a:r>
              <a:rPr lang="en-GB" sz="6000" err="1"/>
              <a:t>nSP</a:t>
            </a:r>
            <a:r>
              <a:rPr lang="en-GB" sz="6000"/>
              <a:t> -  MF</a:t>
            </a:r>
            <a:endParaRPr lang="en-IT" sz="600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E546CA-30C6-F9DB-9C8A-290C176A8A44}"/>
              </a:ext>
            </a:extLst>
          </p:cNvPr>
          <p:cNvSpPr txBox="1"/>
          <p:nvPr/>
        </p:nvSpPr>
        <p:spPr>
          <a:xfrm>
            <a:off x="29766312" y="91376"/>
            <a:ext cx="443320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0" b="1"/>
              <a:t>Figure S4</a:t>
            </a:r>
            <a:endParaRPr lang="en-IT" sz="8000" b="1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40F74219-1514-BAEF-0B76-6EC239CFD9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600" y="2251442"/>
            <a:ext cx="33710880" cy="13484352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871B4BE-72A1-FD90-D3C0-DD74275AB8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8600" y="19804754"/>
            <a:ext cx="33710878" cy="13484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6903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F5AF13-EDA7-086C-4CCB-7247B1DE2E0D}"/>
              </a:ext>
            </a:extLst>
          </p:cNvPr>
          <p:cNvSpPr txBox="1"/>
          <p:nvPr/>
        </p:nvSpPr>
        <p:spPr>
          <a:xfrm>
            <a:off x="29001233" y="596673"/>
            <a:ext cx="443320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0" b="1"/>
              <a:t>Figure S5</a:t>
            </a:r>
            <a:endParaRPr lang="en-IT" sz="8000" b="1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6DF4440-C5C6-98A7-1356-A2D30915A1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4514" y="1668144"/>
            <a:ext cx="15815242" cy="1581524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59A483D-B6A5-8F54-4F88-5CB4CEA8ADDB}"/>
              </a:ext>
            </a:extLst>
          </p:cNvPr>
          <p:cNvSpPr txBox="1"/>
          <p:nvPr/>
        </p:nvSpPr>
        <p:spPr>
          <a:xfrm>
            <a:off x="1929920" y="2121272"/>
            <a:ext cx="12405332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T" sz="8800"/>
              <a:t>A. fishercomb_pval_hist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E64C72E-F3C1-A225-DA14-0A1883E208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99756" y="1802002"/>
            <a:ext cx="15681384" cy="1568138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D9460F2-3710-D345-0802-9515DCD9D5DB}"/>
              </a:ext>
            </a:extLst>
          </p:cNvPr>
          <p:cNvSpPr txBox="1"/>
          <p:nvPr/>
        </p:nvSpPr>
        <p:spPr>
          <a:xfrm>
            <a:off x="18464966" y="2121272"/>
            <a:ext cx="13154621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T" sz="8800"/>
              <a:t>B. invnorm_pval_his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3A6C9B3-5297-1FFD-0B15-1376270D46F9}"/>
              </a:ext>
            </a:extLst>
          </p:cNvPr>
          <p:cNvSpPr txBox="1"/>
          <p:nvPr/>
        </p:nvSpPr>
        <p:spPr>
          <a:xfrm>
            <a:off x="1929920" y="19418672"/>
            <a:ext cx="14575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T" sz="6000"/>
              <a:t>C. Venn GEO TCGA meta  ALL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6A795BDE-2E0B-25C4-0C9F-4379D57840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19424" y="21250909"/>
            <a:ext cx="12026323" cy="1202632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FF5EAE8-2B45-FA50-B860-F138A1DDC7B8}"/>
              </a:ext>
            </a:extLst>
          </p:cNvPr>
          <p:cNvSpPr txBox="1"/>
          <p:nvPr/>
        </p:nvSpPr>
        <p:spPr>
          <a:xfrm>
            <a:off x="18464966" y="19418672"/>
            <a:ext cx="1476620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T" sz="6000"/>
              <a:t>D. Venn GEO TCGA meta SUB </a:t>
            </a:r>
          </a:p>
        </p:txBody>
      </p:sp>
    </p:spTree>
    <p:extLst>
      <p:ext uri="{BB962C8B-B14F-4D97-AF65-F5344CB8AC3E}">
        <p14:creationId xmlns:p14="http://schemas.microsoft.com/office/powerpoint/2010/main" val="6294431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2FD2DFC-1281-4B36-76CB-ED5BBF0E80B0}"/>
              </a:ext>
            </a:extLst>
          </p:cNvPr>
          <p:cNvSpPr txBox="1"/>
          <p:nvPr/>
        </p:nvSpPr>
        <p:spPr>
          <a:xfrm>
            <a:off x="29148736" y="598931"/>
            <a:ext cx="4433201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0" b="1"/>
              <a:t>Figure S6</a:t>
            </a:r>
            <a:endParaRPr lang="en-IT" sz="8000" b="1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0EF393F-8781-7E4B-99A5-3676CA5235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6474" y="-244074"/>
            <a:ext cx="13067030" cy="1275167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8F3418D-5563-CC4F-9C37-57CEA4DA27F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9010" b="19045"/>
          <a:stretch/>
        </p:blipFill>
        <p:spPr>
          <a:xfrm>
            <a:off x="17890874" y="1766223"/>
            <a:ext cx="14081284" cy="872248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E834D75-7840-3741-AF58-73ED76BB3CA2}"/>
              </a:ext>
            </a:extLst>
          </p:cNvPr>
          <p:cNvSpPr txBox="1"/>
          <p:nvPr/>
        </p:nvSpPr>
        <p:spPr>
          <a:xfrm>
            <a:off x="617576" y="567680"/>
            <a:ext cx="9454191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A</a:t>
            </a:r>
            <a:r>
              <a:rPr lang="en-IT" sz="6000"/>
              <a:t> </a:t>
            </a:r>
            <a:r>
              <a:rPr lang="en-IT" sz="6000" i="1"/>
              <a:t>GSE90711</a:t>
            </a:r>
            <a:r>
              <a:rPr lang="en-GB" sz="6000" i="1">
                <a:effectLst/>
                <a:latin typeface="Inconsolatazi4"/>
              </a:rPr>
              <a:t>PCA distribution </a:t>
            </a:r>
            <a:endParaRPr lang="en-IT" sz="6000" i="1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F41D39C-B09E-2146-8633-A10568B797AA}"/>
              </a:ext>
            </a:extLst>
          </p:cNvPr>
          <p:cNvSpPr txBox="1"/>
          <p:nvPr/>
        </p:nvSpPr>
        <p:spPr>
          <a:xfrm>
            <a:off x="617576" y="19993718"/>
            <a:ext cx="1084213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D</a:t>
            </a:r>
            <a:r>
              <a:rPr lang="en-IT" sz="6000"/>
              <a:t> </a:t>
            </a:r>
            <a:r>
              <a:rPr lang="it-IT" sz="6000" i="1" err="1"/>
              <a:t>Enrichment</a:t>
            </a:r>
            <a:r>
              <a:rPr lang="it-IT" sz="6000" i="1"/>
              <a:t>  </a:t>
            </a:r>
            <a:r>
              <a:rPr lang="it-IT" sz="6000" i="1" err="1"/>
              <a:t>barplots</a:t>
            </a:r>
            <a:r>
              <a:rPr lang="it-IT" sz="6000" i="1"/>
              <a:t> on </a:t>
            </a:r>
            <a:r>
              <a:rPr lang="it-IT" sz="6000" i="1" err="1"/>
              <a:t>DEGs</a:t>
            </a:r>
            <a:endParaRPr lang="en-IT" sz="6000" i="1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9525008-BE3A-B34C-8331-A546762E09FD}"/>
              </a:ext>
            </a:extLst>
          </p:cNvPr>
          <p:cNvSpPr txBox="1"/>
          <p:nvPr/>
        </p:nvSpPr>
        <p:spPr>
          <a:xfrm>
            <a:off x="617576" y="10715581"/>
            <a:ext cx="1186626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B</a:t>
            </a:r>
            <a:r>
              <a:rPr lang="en-IT" sz="6000"/>
              <a:t> </a:t>
            </a:r>
            <a:r>
              <a:rPr lang="it-IT" sz="6000" i="1"/>
              <a:t>Common </a:t>
            </a:r>
            <a:r>
              <a:rPr lang="it-IT" sz="6000" i="1" err="1"/>
              <a:t>SPCGs</a:t>
            </a:r>
            <a:r>
              <a:rPr lang="it-IT" sz="6000" i="1"/>
              <a:t> </a:t>
            </a:r>
            <a:r>
              <a:rPr lang="it-IT" sz="6000" i="1" err="1"/>
              <a:t>across</a:t>
            </a:r>
            <a:r>
              <a:rPr lang="it-IT" sz="6000" i="1"/>
              <a:t> </a:t>
            </a:r>
            <a:r>
              <a:rPr lang="it-IT" sz="6000" i="1" err="1"/>
              <a:t>datasets</a:t>
            </a:r>
            <a:endParaRPr lang="en-IT" sz="6000" i="1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6FACDB-F556-F348-988E-94A2AE136D95}"/>
              </a:ext>
            </a:extLst>
          </p:cNvPr>
          <p:cNvSpPr txBox="1"/>
          <p:nvPr/>
        </p:nvSpPr>
        <p:spPr>
          <a:xfrm>
            <a:off x="617576" y="36753088"/>
            <a:ext cx="1348252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6000" b="1"/>
              <a:t>F</a:t>
            </a:r>
            <a:r>
              <a:rPr lang="en-IT" sz="6000"/>
              <a:t> </a:t>
            </a:r>
            <a:r>
              <a:rPr lang="it-IT" sz="6000" i="1"/>
              <a:t>Common </a:t>
            </a:r>
            <a:r>
              <a:rPr lang="it-IT" sz="6000" i="1" err="1"/>
              <a:t>SPCGs</a:t>
            </a:r>
            <a:r>
              <a:rPr lang="it-IT" sz="6000" i="1"/>
              <a:t> </a:t>
            </a:r>
            <a:r>
              <a:rPr lang="it-IT" sz="6000" i="1" err="1"/>
              <a:t>across</a:t>
            </a:r>
            <a:r>
              <a:rPr lang="it-IT" sz="6000" i="1"/>
              <a:t> datasets after </a:t>
            </a:r>
            <a:r>
              <a:rPr lang="it-IT" sz="6000" i="1" err="1"/>
              <a:t>stingent</a:t>
            </a:r>
            <a:r>
              <a:rPr lang="it-IT" sz="6000" i="1"/>
              <a:t> </a:t>
            </a:r>
            <a:r>
              <a:rPr lang="it-IT" sz="6000" i="1" err="1"/>
              <a:t>filering</a:t>
            </a:r>
            <a:r>
              <a:rPr lang="it-IT" sz="6000" i="1"/>
              <a:t> on </a:t>
            </a:r>
            <a:r>
              <a:rPr lang="it-IT" sz="6000" i="1" err="1"/>
              <a:t>Mean_CPM_C</a:t>
            </a:r>
            <a:endParaRPr lang="en-IT" sz="6000" i="1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BB8538B-902D-9B40-AA8F-A73C81D6E79E}"/>
              </a:ext>
            </a:extLst>
          </p:cNvPr>
          <p:cNvSpPr txBox="1"/>
          <p:nvPr/>
        </p:nvSpPr>
        <p:spPr>
          <a:xfrm>
            <a:off x="16036730" y="10715581"/>
            <a:ext cx="158868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6000" b="1"/>
              <a:t>C</a:t>
            </a:r>
            <a:r>
              <a:rPr lang="en-IT" sz="6000"/>
              <a:t> </a:t>
            </a:r>
            <a:r>
              <a:rPr lang="it-IT" sz="6000" i="1" err="1"/>
              <a:t>Almen</a:t>
            </a:r>
            <a:r>
              <a:rPr lang="it-IT" sz="6000" i="1"/>
              <a:t> class </a:t>
            </a:r>
            <a:r>
              <a:rPr lang="it-IT" sz="6000" i="1" err="1"/>
              <a:t>definition</a:t>
            </a:r>
            <a:r>
              <a:rPr lang="it-IT" sz="6000" i="1"/>
              <a:t> of 83 common SPC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8AA096-EAE8-0142-8015-CCD7FBDF1AB2}"/>
              </a:ext>
            </a:extLst>
          </p:cNvPr>
          <p:cNvSpPr txBox="1"/>
          <p:nvPr/>
        </p:nvSpPr>
        <p:spPr>
          <a:xfrm>
            <a:off x="16546543" y="36753088"/>
            <a:ext cx="1726312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6000" b="1"/>
              <a:t>G</a:t>
            </a:r>
            <a:r>
              <a:rPr lang="en-IT" sz="6000"/>
              <a:t>  </a:t>
            </a:r>
            <a:r>
              <a:rPr lang="it-IT" sz="6000" i="1" err="1"/>
              <a:t>Almen</a:t>
            </a:r>
            <a:r>
              <a:rPr lang="it-IT" sz="6000" i="1"/>
              <a:t> </a:t>
            </a:r>
            <a:r>
              <a:rPr lang="it-IT" sz="6000" i="1" err="1"/>
              <a:t>class</a:t>
            </a:r>
            <a:r>
              <a:rPr lang="it-IT" sz="6000" i="1"/>
              <a:t> </a:t>
            </a:r>
            <a:r>
              <a:rPr lang="it-IT" sz="6000" i="1" err="1"/>
              <a:t>definition</a:t>
            </a:r>
            <a:r>
              <a:rPr lang="it-IT" sz="6000" i="1"/>
              <a:t> of common SPCG </a:t>
            </a:r>
            <a:r>
              <a:rPr lang="it-IT" sz="6000" i="1" err="1"/>
              <a:t>across</a:t>
            </a:r>
            <a:r>
              <a:rPr lang="it-IT" sz="6000" i="1"/>
              <a:t> </a:t>
            </a:r>
            <a:r>
              <a:rPr lang="it-IT" sz="6000" i="1" err="1"/>
              <a:t>datasets</a:t>
            </a:r>
            <a:r>
              <a:rPr lang="it-IT" sz="6000" i="1"/>
              <a:t> </a:t>
            </a:r>
            <a:r>
              <a:rPr lang="it-IT" sz="6000" i="1" err="1"/>
              <a:t>after</a:t>
            </a:r>
            <a:r>
              <a:rPr lang="it-IT" sz="6000" i="1"/>
              <a:t> </a:t>
            </a:r>
            <a:r>
              <a:rPr lang="it-IT" sz="6000" i="1" err="1"/>
              <a:t>stringent</a:t>
            </a:r>
            <a:r>
              <a:rPr lang="it-IT" sz="6000" i="1"/>
              <a:t> </a:t>
            </a:r>
            <a:r>
              <a:rPr lang="it-IT" sz="6000" i="1" err="1"/>
              <a:t>filtering</a:t>
            </a:r>
            <a:r>
              <a:rPr lang="it-IT" sz="6000" i="1"/>
              <a:t> on </a:t>
            </a:r>
            <a:r>
              <a:rPr lang="it-IT" sz="6000" i="1" err="1"/>
              <a:t>Mean_CPM_C</a:t>
            </a:r>
            <a:endParaRPr lang="it-IT" sz="6000" i="1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2115BC81-3BB0-F84C-82A0-4353B73BB06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6593" b="22647"/>
          <a:stretch/>
        </p:blipFill>
        <p:spPr>
          <a:xfrm>
            <a:off x="2218346" y="39579022"/>
            <a:ext cx="10553609" cy="641231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41EF0D0-C182-E84F-AEBB-21B1213EC9E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0045" b="22741"/>
          <a:stretch/>
        </p:blipFill>
        <p:spPr>
          <a:xfrm>
            <a:off x="1014067" y="12876290"/>
            <a:ext cx="11602853" cy="6638551"/>
          </a:xfrm>
          <a:prstGeom prst="rect">
            <a:avLst/>
          </a:prstGeom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8805FCA2-7844-944F-94DB-7884E49D1B10}"/>
              </a:ext>
            </a:extLst>
          </p:cNvPr>
          <p:cNvSpPr/>
          <p:nvPr/>
        </p:nvSpPr>
        <p:spPr>
          <a:xfrm>
            <a:off x="5365736" y="22202783"/>
            <a:ext cx="1049067" cy="3831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0389A31D-0629-4441-A5ED-ADAB98856D5C}"/>
              </a:ext>
            </a:extLst>
          </p:cNvPr>
          <p:cNvSpPr/>
          <p:nvPr/>
        </p:nvSpPr>
        <p:spPr>
          <a:xfrm>
            <a:off x="17714775" y="22335078"/>
            <a:ext cx="1049067" cy="3831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B02632C-9FB4-A442-858D-5CAD4C0997A2}"/>
              </a:ext>
            </a:extLst>
          </p:cNvPr>
          <p:cNvSpPr txBox="1"/>
          <p:nvPr/>
        </p:nvSpPr>
        <p:spPr>
          <a:xfrm>
            <a:off x="617576" y="28648601"/>
            <a:ext cx="1436925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6000" b="1"/>
              <a:t>E</a:t>
            </a:r>
            <a:r>
              <a:rPr lang="en-IT" sz="6000"/>
              <a:t> </a:t>
            </a:r>
            <a:r>
              <a:rPr lang="it-IT" sz="6000" i="1" err="1"/>
              <a:t>Enrichment</a:t>
            </a:r>
            <a:r>
              <a:rPr lang="it-IT" sz="6000" i="1"/>
              <a:t>  </a:t>
            </a:r>
            <a:r>
              <a:rPr lang="it-IT" sz="6000" i="1" err="1"/>
              <a:t>barplots</a:t>
            </a:r>
            <a:r>
              <a:rPr lang="it-IT" sz="6000" i="1"/>
              <a:t> on common </a:t>
            </a:r>
            <a:r>
              <a:rPr lang="it-IT" sz="6000" i="1" err="1"/>
              <a:t>SPCGs</a:t>
            </a:r>
            <a:endParaRPr lang="en-IT" sz="6000" i="1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BD29801C-F5A4-5C44-8299-8BB817192887}"/>
              </a:ext>
            </a:extLst>
          </p:cNvPr>
          <p:cNvSpPr/>
          <p:nvPr/>
        </p:nvSpPr>
        <p:spPr>
          <a:xfrm>
            <a:off x="5637426" y="29760916"/>
            <a:ext cx="1049067" cy="3831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3669A6E7-6E12-6447-9EBD-E48F4DE62557}"/>
              </a:ext>
            </a:extLst>
          </p:cNvPr>
          <p:cNvSpPr/>
          <p:nvPr/>
        </p:nvSpPr>
        <p:spPr>
          <a:xfrm>
            <a:off x="17484196" y="29575473"/>
            <a:ext cx="1049067" cy="3831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IT"/>
          </a:p>
        </p:txBody>
      </p:sp>
      <p:pic>
        <p:nvPicPr>
          <p:cNvPr id="12" name="Picture 11" descr="A graph of cell division&#10;&#10;Description automatically generated with medium confidence">
            <a:extLst>
              <a:ext uri="{FF2B5EF4-FFF2-40B4-BE49-F238E27FC236}">
                <a16:creationId xmlns:a16="http://schemas.microsoft.com/office/drawing/2014/main" id="{8E9BFB8D-7230-7415-846D-089FDF3E81A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72372" y="21339795"/>
            <a:ext cx="15111941" cy="6480000"/>
          </a:xfrm>
          <a:prstGeom prst="rect">
            <a:avLst/>
          </a:prstGeom>
        </p:spPr>
      </p:pic>
      <p:pic>
        <p:nvPicPr>
          <p:cNvPr id="18" name="Picture 17" descr="A graph with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3C76B2DC-920A-69B6-836B-496E12039A6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860218" y="21339795"/>
            <a:ext cx="15111940" cy="6480000"/>
          </a:xfrm>
          <a:prstGeom prst="rect">
            <a:avLst/>
          </a:prstGeom>
        </p:spPr>
      </p:pic>
      <p:pic>
        <p:nvPicPr>
          <p:cNvPr id="20" name="Picture 19" descr="A graph with a red and blue bar&#10;&#10;Description automatically generated">
            <a:extLst>
              <a:ext uri="{FF2B5EF4-FFF2-40B4-BE49-F238E27FC236}">
                <a16:creationId xmlns:a16="http://schemas.microsoft.com/office/drawing/2014/main" id="{E186E5FE-5CF4-0CFA-682D-BF1D876F83B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14067" y="29930207"/>
            <a:ext cx="15111941" cy="6480000"/>
          </a:xfrm>
          <a:prstGeom prst="rect">
            <a:avLst/>
          </a:prstGeom>
        </p:spPr>
      </p:pic>
      <p:pic>
        <p:nvPicPr>
          <p:cNvPr id="28" name="Picture 27" descr="A graph showing a number of different colored squares&#10;&#10;Description automatically generated">
            <a:extLst>
              <a:ext uri="{FF2B5EF4-FFF2-40B4-BE49-F238E27FC236}">
                <a16:creationId xmlns:a16="http://schemas.microsoft.com/office/drawing/2014/main" id="{926C3434-2F77-FA3C-2611-1C414283AF9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763842" y="39711092"/>
            <a:ext cx="11110360" cy="6491735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C31556D3-F536-0683-24AF-7EAF556E942A}"/>
              </a:ext>
            </a:extLst>
          </p:cNvPr>
          <p:cNvSpPr txBox="1"/>
          <p:nvPr/>
        </p:nvSpPr>
        <p:spPr>
          <a:xfrm>
            <a:off x="22137405" y="43415668"/>
            <a:ext cx="194425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>
                <a:effectLst/>
              </a:rPr>
              <a:t>HLA-G</a:t>
            </a:r>
            <a:endParaRPr lang="en-IT" sz="480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03724A-229C-77B8-EE5F-D0F91B56EAD1}"/>
              </a:ext>
            </a:extLst>
          </p:cNvPr>
          <p:cNvSpPr txBox="1"/>
          <p:nvPr/>
        </p:nvSpPr>
        <p:spPr>
          <a:xfrm>
            <a:off x="26044049" y="41234174"/>
            <a:ext cx="196079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>
                <a:effectLst/>
              </a:rPr>
              <a:t>HTR1E</a:t>
            </a:r>
            <a:endParaRPr lang="en-IT" sz="480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70EEBB7-A9D1-C0DB-59CE-EA2AA685A048}"/>
              </a:ext>
            </a:extLst>
          </p:cNvPr>
          <p:cNvSpPr txBox="1"/>
          <p:nvPr/>
        </p:nvSpPr>
        <p:spPr>
          <a:xfrm>
            <a:off x="26044049" y="43425558"/>
            <a:ext cx="223490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4800">
                <a:effectLst/>
              </a:rPr>
              <a:t>MCHR1</a:t>
            </a:r>
            <a:endParaRPr lang="en-IT" sz="4800"/>
          </a:p>
        </p:txBody>
      </p:sp>
      <p:pic>
        <p:nvPicPr>
          <p:cNvPr id="33" name="Picture 32" descr="A graph of different colored squares&#10;&#10;Description automatically generated">
            <a:extLst>
              <a:ext uri="{FF2B5EF4-FFF2-40B4-BE49-F238E27FC236}">
                <a16:creationId xmlns:a16="http://schemas.microsoft.com/office/drawing/2014/main" id="{EA0C5E68-EF8B-2BA5-C5C2-69644C65E34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761846" y="12835959"/>
            <a:ext cx="16210312" cy="6934891"/>
          </a:xfrm>
          <a:prstGeom prst="rect">
            <a:avLst/>
          </a:prstGeom>
        </p:spPr>
      </p:pic>
      <p:pic>
        <p:nvPicPr>
          <p:cNvPr id="4" name="Picture 3" descr="A graph with different colored bars&#10;&#10;Description automatically generated">
            <a:extLst>
              <a:ext uri="{FF2B5EF4-FFF2-40B4-BE49-F238E27FC236}">
                <a16:creationId xmlns:a16="http://schemas.microsoft.com/office/drawing/2014/main" id="{0E1C23B8-9870-49E8-BCE5-3A914FE9758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375545" y="29930207"/>
            <a:ext cx="15111941" cy="64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637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Application>Microsoft Office PowerPoint</Application>
  <PresentationFormat>Custom</PresentationFormat>
  <Slides>6</Slides>
  <Notes>6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scini Anna Sofia</dc:creator>
  <cp:revision>1</cp:revision>
  <dcterms:created xsi:type="dcterms:W3CDTF">2024-05-07T08:35:38Z</dcterms:created>
  <dcterms:modified xsi:type="dcterms:W3CDTF">2024-10-23T16:30:44Z</dcterms:modified>
</cp:coreProperties>
</file>